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40436994347832"/>
          <c:y val="0.13417190775681337"/>
          <c:w val="0.81775698553363618"/>
          <c:h val="0.7358490566037954"/>
        </c:manualLayout>
      </c:layout>
      <c:scatterChart>
        <c:scatterStyle val="lineMarker"/>
        <c:varyColors val="0"/>
        <c:ser>
          <c:idx val="2"/>
          <c:order val="0"/>
          <c:tx>
            <c:v>WG335/3</c:v>
          </c:tx>
          <c:spPr>
            <a:ln w="25400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Data!$A$84:$A$604</c:f>
              <c:numCache>
                <c:formatCode>General</c:formatCode>
                <c:ptCount val="521"/>
                <c:pt idx="0">
                  <c:v>280</c:v>
                </c:pt>
                <c:pt idx="1">
                  <c:v>281</c:v>
                </c:pt>
                <c:pt idx="2">
                  <c:v>282</c:v>
                </c:pt>
                <c:pt idx="3">
                  <c:v>283</c:v>
                </c:pt>
                <c:pt idx="4">
                  <c:v>284</c:v>
                </c:pt>
                <c:pt idx="5">
                  <c:v>285</c:v>
                </c:pt>
                <c:pt idx="6">
                  <c:v>286</c:v>
                </c:pt>
                <c:pt idx="7">
                  <c:v>287</c:v>
                </c:pt>
                <c:pt idx="8">
                  <c:v>288</c:v>
                </c:pt>
                <c:pt idx="9">
                  <c:v>289</c:v>
                </c:pt>
                <c:pt idx="10">
                  <c:v>290</c:v>
                </c:pt>
                <c:pt idx="11">
                  <c:v>291</c:v>
                </c:pt>
                <c:pt idx="12">
                  <c:v>292</c:v>
                </c:pt>
                <c:pt idx="13">
                  <c:v>293</c:v>
                </c:pt>
                <c:pt idx="14">
                  <c:v>294</c:v>
                </c:pt>
                <c:pt idx="15">
                  <c:v>295</c:v>
                </c:pt>
                <c:pt idx="16">
                  <c:v>296</c:v>
                </c:pt>
                <c:pt idx="17">
                  <c:v>297</c:v>
                </c:pt>
                <c:pt idx="18">
                  <c:v>298</c:v>
                </c:pt>
                <c:pt idx="19">
                  <c:v>299</c:v>
                </c:pt>
                <c:pt idx="20">
                  <c:v>300</c:v>
                </c:pt>
                <c:pt idx="21">
                  <c:v>301</c:v>
                </c:pt>
                <c:pt idx="22">
                  <c:v>302</c:v>
                </c:pt>
                <c:pt idx="23">
                  <c:v>303</c:v>
                </c:pt>
                <c:pt idx="24">
                  <c:v>304</c:v>
                </c:pt>
                <c:pt idx="25">
                  <c:v>305</c:v>
                </c:pt>
                <c:pt idx="26">
                  <c:v>306</c:v>
                </c:pt>
                <c:pt idx="27">
                  <c:v>307</c:v>
                </c:pt>
                <c:pt idx="28">
                  <c:v>308</c:v>
                </c:pt>
                <c:pt idx="29">
                  <c:v>309</c:v>
                </c:pt>
                <c:pt idx="30">
                  <c:v>310</c:v>
                </c:pt>
                <c:pt idx="31">
                  <c:v>311</c:v>
                </c:pt>
                <c:pt idx="32">
                  <c:v>312</c:v>
                </c:pt>
                <c:pt idx="33">
                  <c:v>313</c:v>
                </c:pt>
                <c:pt idx="34">
                  <c:v>314</c:v>
                </c:pt>
                <c:pt idx="35">
                  <c:v>315</c:v>
                </c:pt>
                <c:pt idx="36">
                  <c:v>316</c:v>
                </c:pt>
                <c:pt idx="37">
                  <c:v>317</c:v>
                </c:pt>
                <c:pt idx="38">
                  <c:v>318</c:v>
                </c:pt>
                <c:pt idx="39">
                  <c:v>319</c:v>
                </c:pt>
                <c:pt idx="40">
                  <c:v>320</c:v>
                </c:pt>
                <c:pt idx="41">
                  <c:v>321</c:v>
                </c:pt>
                <c:pt idx="42">
                  <c:v>322</c:v>
                </c:pt>
                <c:pt idx="43">
                  <c:v>323</c:v>
                </c:pt>
                <c:pt idx="44">
                  <c:v>324</c:v>
                </c:pt>
                <c:pt idx="45">
                  <c:v>325</c:v>
                </c:pt>
                <c:pt idx="46">
                  <c:v>326</c:v>
                </c:pt>
                <c:pt idx="47">
                  <c:v>327</c:v>
                </c:pt>
                <c:pt idx="48">
                  <c:v>328</c:v>
                </c:pt>
                <c:pt idx="49">
                  <c:v>329</c:v>
                </c:pt>
                <c:pt idx="50">
                  <c:v>330</c:v>
                </c:pt>
                <c:pt idx="51">
                  <c:v>331</c:v>
                </c:pt>
                <c:pt idx="52">
                  <c:v>332</c:v>
                </c:pt>
                <c:pt idx="53">
                  <c:v>333</c:v>
                </c:pt>
                <c:pt idx="54">
                  <c:v>334</c:v>
                </c:pt>
                <c:pt idx="55">
                  <c:v>335</c:v>
                </c:pt>
                <c:pt idx="56">
                  <c:v>336</c:v>
                </c:pt>
                <c:pt idx="57">
                  <c:v>337</c:v>
                </c:pt>
                <c:pt idx="58">
                  <c:v>338</c:v>
                </c:pt>
                <c:pt idx="59">
                  <c:v>339</c:v>
                </c:pt>
                <c:pt idx="60">
                  <c:v>340</c:v>
                </c:pt>
                <c:pt idx="61">
                  <c:v>341</c:v>
                </c:pt>
                <c:pt idx="62">
                  <c:v>342</c:v>
                </c:pt>
                <c:pt idx="63">
                  <c:v>343</c:v>
                </c:pt>
                <c:pt idx="64">
                  <c:v>344</c:v>
                </c:pt>
                <c:pt idx="65">
                  <c:v>345</c:v>
                </c:pt>
                <c:pt idx="66">
                  <c:v>346</c:v>
                </c:pt>
                <c:pt idx="67">
                  <c:v>347</c:v>
                </c:pt>
                <c:pt idx="68">
                  <c:v>348</c:v>
                </c:pt>
                <c:pt idx="69">
                  <c:v>349</c:v>
                </c:pt>
                <c:pt idx="70">
                  <c:v>350</c:v>
                </c:pt>
                <c:pt idx="71">
                  <c:v>351</c:v>
                </c:pt>
                <c:pt idx="72">
                  <c:v>352</c:v>
                </c:pt>
                <c:pt idx="73">
                  <c:v>353</c:v>
                </c:pt>
                <c:pt idx="74">
                  <c:v>354</c:v>
                </c:pt>
                <c:pt idx="75">
                  <c:v>355</c:v>
                </c:pt>
                <c:pt idx="76">
                  <c:v>356</c:v>
                </c:pt>
                <c:pt idx="77">
                  <c:v>357</c:v>
                </c:pt>
                <c:pt idx="78">
                  <c:v>358</c:v>
                </c:pt>
                <c:pt idx="79">
                  <c:v>359</c:v>
                </c:pt>
                <c:pt idx="80">
                  <c:v>360</c:v>
                </c:pt>
                <c:pt idx="81">
                  <c:v>361</c:v>
                </c:pt>
                <c:pt idx="82">
                  <c:v>362</c:v>
                </c:pt>
                <c:pt idx="83">
                  <c:v>363</c:v>
                </c:pt>
                <c:pt idx="84">
                  <c:v>364</c:v>
                </c:pt>
                <c:pt idx="85">
                  <c:v>365</c:v>
                </c:pt>
                <c:pt idx="86">
                  <c:v>366</c:v>
                </c:pt>
                <c:pt idx="87">
                  <c:v>367</c:v>
                </c:pt>
                <c:pt idx="88">
                  <c:v>368</c:v>
                </c:pt>
                <c:pt idx="89">
                  <c:v>369</c:v>
                </c:pt>
                <c:pt idx="90">
                  <c:v>370</c:v>
                </c:pt>
                <c:pt idx="91">
                  <c:v>371</c:v>
                </c:pt>
                <c:pt idx="92">
                  <c:v>372</c:v>
                </c:pt>
                <c:pt idx="93">
                  <c:v>373</c:v>
                </c:pt>
                <c:pt idx="94">
                  <c:v>374</c:v>
                </c:pt>
                <c:pt idx="95">
                  <c:v>375</c:v>
                </c:pt>
                <c:pt idx="96">
                  <c:v>376</c:v>
                </c:pt>
                <c:pt idx="97">
                  <c:v>377</c:v>
                </c:pt>
                <c:pt idx="98">
                  <c:v>378</c:v>
                </c:pt>
                <c:pt idx="99">
                  <c:v>379</c:v>
                </c:pt>
                <c:pt idx="100">
                  <c:v>380</c:v>
                </c:pt>
                <c:pt idx="101">
                  <c:v>381</c:v>
                </c:pt>
                <c:pt idx="102">
                  <c:v>382</c:v>
                </c:pt>
                <c:pt idx="103">
                  <c:v>383</c:v>
                </c:pt>
                <c:pt idx="104">
                  <c:v>384</c:v>
                </c:pt>
                <c:pt idx="105">
                  <c:v>385</c:v>
                </c:pt>
                <c:pt idx="106">
                  <c:v>386</c:v>
                </c:pt>
                <c:pt idx="107">
                  <c:v>387</c:v>
                </c:pt>
                <c:pt idx="108">
                  <c:v>388</c:v>
                </c:pt>
                <c:pt idx="109">
                  <c:v>389</c:v>
                </c:pt>
                <c:pt idx="110">
                  <c:v>390</c:v>
                </c:pt>
                <c:pt idx="111">
                  <c:v>391</c:v>
                </c:pt>
                <c:pt idx="112">
                  <c:v>392</c:v>
                </c:pt>
                <c:pt idx="113">
                  <c:v>393</c:v>
                </c:pt>
                <c:pt idx="114">
                  <c:v>394</c:v>
                </c:pt>
                <c:pt idx="115">
                  <c:v>395</c:v>
                </c:pt>
                <c:pt idx="116">
                  <c:v>396</c:v>
                </c:pt>
                <c:pt idx="117">
                  <c:v>397</c:v>
                </c:pt>
                <c:pt idx="118">
                  <c:v>398</c:v>
                </c:pt>
                <c:pt idx="119">
                  <c:v>399</c:v>
                </c:pt>
                <c:pt idx="120">
                  <c:v>400</c:v>
                </c:pt>
                <c:pt idx="121">
                  <c:v>401</c:v>
                </c:pt>
                <c:pt idx="122">
                  <c:v>402</c:v>
                </c:pt>
                <c:pt idx="123">
                  <c:v>403</c:v>
                </c:pt>
                <c:pt idx="124">
                  <c:v>404</c:v>
                </c:pt>
                <c:pt idx="125">
                  <c:v>405</c:v>
                </c:pt>
                <c:pt idx="126">
                  <c:v>406</c:v>
                </c:pt>
                <c:pt idx="127">
                  <c:v>407</c:v>
                </c:pt>
                <c:pt idx="128">
                  <c:v>408</c:v>
                </c:pt>
                <c:pt idx="129">
                  <c:v>409</c:v>
                </c:pt>
                <c:pt idx="130">
                  <c:v>410</c:v>
                </c:pt>
                <c:pt idx="131">
                  <c:v>411</c:v>
                </c:pt>
                <c:pt idx="132">
                  <c:v>412</c:v>
                </c:pt>
                <c:pt idx="133">
                  <c:v>413</c:v>
                </c:pt>
                <c:pt idx="134">
                  <c:v>414</c:v>
                </c:pt>
                <c:pt idx="135">
                  <c:v>415</c:v>
                </c:pt>
                <c:pt idx="136">
                  <c:v>416</c:v>
                </c:pt>
                <c:pt idx="137">
                  <c:v>417</c:v>
                </c:pt>
                <c:pt idx="138">
                  <c:v>418</c:v>
                </c:pt>
                <c:pt idx="139">
                  <c:v>419</c:v>
                </c:pt>
                <c:pt idx="140">
                  <c:v>420</c:v>
                </c:pt>
                <c:pt idx="141">
                  <c:v>421</c:v>
                </c:pt>
                <c:pt idx="142">
                  <c:v>422</c:v>
                </c:pt>
                <c:pt idx="143">
                  <c:v>423</c:v>
                </c:pt>
                <c:pt idx="144">
                  <c:v>424</c:v>
                </c:pt>
                <c:pt idx="145">
                  <c:v>425</c:v>
                </c:pt>
                <c:pt idx="146">
                  <c:v>426</c:v>
                </c:pt>
                <c:pt idx="147">
                  <c:v>427</c:v>
                </c:pt>
                <c:pt idx="148">
                  <c:v>428</c:v>
                </c:pt>
                <c:pt idx="149">
                  <c:v>429</c:v>
                </c:pt>
                <c:pt idx="150">
                  <c:v>430</c:v>
                </c:pt>
                <c:pt idx="151">
                  <c:v>431</c:v>
                </c:pt>
                <c:pt idx="152">
                  <c:v>432</c:v>
                </c:pt>
                <c:pt idx="153">
                  <c:v>433</c:v>
                </c:pt>
                <c:pt idx="154">
                  <c:v>434</c:v>
                </c:pt>
                <c:pt idx="155">
                  <c:v>435</c:v>
                </c:pt>
                <c:pt idx="156">
                  <c:v>436</c:v>
                </c:pt>
                <c:pt idx="157">
                  <c:v>437</c:v>
                </c:pt>
                <c:pt idx="158">
                  <c:v>438</c:v>
                </c:pt>
                <c:pt idx="159">
                  <c:v>439</c:v>
                </c:pt>
                <c:pt idx="160">
                  <c:v>440</c:v>
                </c:pt>
                <c:pt idx="161">
                  <c:v>441</c:v>
                </c:pt>
                <c:pt idx="162">
                  <c:v>442</c:v>
                </c:pt>
                <c:pt idx="163">
                  <c:v>443</c:v>
                </c:pt>
                <c:pt idx="164">
                  <c:v>444</c:v>
                </c:pt>
                <c:pt idx="165">
                  <c:v>445</c:v>
                </c:pt>
                <c:pt idx="166">
                  <c:v>446</c:v>
                </c:pt>
                <c:pt idx="167">
                  <c:v>447</c:v>
                </c:pt>
                <c:pt idx="168">
                  <c:v>448</c:v>
                </c:pt>
                <c:pt idx="169">
                  <c:v>449</c:v>
                </c:pt>
                <c:pt idx="170">
                  <c:v>450</c:v>
                </c:pt>
                <c:pt idx="171">
                  <c:v>451</c:v>
                </c:pt>
                <c:pt idx="172">
                  <c:v>452</c:v>
                </c:pt>
                <c:pt idx="173">
                  <c:v>453</c:v>
                </c:pt>
                <c:pt idx="174">
                  <c:v>454</c:v>
                </c:pt>
                <c:pt idx="175">
                  <c:v>455</c:v>
                </c:pt>
                <c:pt idx="176">
                  <c:v>456</c:v>
                </c:pt>
                <c:pt idx="177">
                  <c:v>457</c:v>
                </c:pt>
                <c:pt idx="178">
                  <c:v>458</c:v>
                </c:pt>
                <c:pt idx="179">
                  <c:v>459</c:v>
                </c:pt>
                <c:pt idx="180">
                  <c:v>460</c:v>
                </c:pt>
                <c:pt idx="181">
                  <c:v>461</c:v>
                </c:pt>
                <c:pt idx="182">
                  <c:v>462</c:v>
                </c:pt>
                <c:pt idx="183">
                  <c:v>463</c:v>
                </c:pt>
                <c:pt idx="184">
                  <c:v>464</c:v>
                </c:pt>
                <c:pt idx="185">
                  <c:v>465</c:v>
                </c:pt>
                <c:pt idx="186">
                  <c:v>466</c:v>
                </c:pt>
                <c:pt idx="187">
                  <c:v>467</c:v>
                </c:pt>
                <c:pt idx="188">
                  <c:v>468</c:v>
                </c:pt>
                <c:pt idx="189">
                  <c:v>469</c:v>
                </c:pt>
                <c:pt idx="190">
                  <c:v>470</c:v>
                </c:pt>
                <c:pt idx="191">
                  <c:v>471</c:v>
                </c:pt>
                <c:pt idx="192">
                  <c:v>472</c:v>
                </c:pt>
                <c:pt idx="193">
                  <c:v>473</c:v>
                </c:pt>
                <c:pt idx="194">
                  <c:v>474</c:v>
                </c:pt>
                <c:pt idx="195">
                  <c:v>475</c:v>
                </c:pt>
                <c:pt idx="196">
                  <c:v>476</c:v>
                </c:pt>
                <c:pt idx="197">
                  <c:v>477</c:v>
                </c:pt>
                <c:pt idx="198">
                  <c:v>478</c:v>
                </c:pt>
                <c:pt idx="199">
                  <c:v>479</c:v>
                </c:pt>
                <c:pt idx="200">
                  <c:v>480</c:v>
                </c:pt>
                <c:pt idx="201">
                  <c:v>481</c:v>
                </c:pt>
                <c:pt idx="202">
                  <c:v>482</c:v>
                </c:pt>
                <c:pt idx="203">
                  <c:v>483</c:v>
                </c:pt>
                <c:pt idx="204">
                  <c:v>484</c:v>
                </c:pt>
                <c:pt idx="205">
                  <c:v>485</c:v>
                </c:pt>
                <c:pt idx="206">
                  <c:v>486</c:v>
                </c:pt>
                <c:pt idx="207">
                  <c:v>487</c:v>
                </c:pt>
                <c:pt idx="208">
                  <c:v>488</c:v>
                </c:pt>
                <c:pt idx="209">
                  <c:v>489</c:v>
                </c:pt>
                <c:pt idx="210">
                  <c:v>490</c:v>
                </c:pt>
                <c:pt idx="211">
                  <c:v>491</c:v>
                </c:pt>
                <c:pt idx="212">
                  <c:v>492</c:v>
                </c:pt>
                <c:pt idx="213">
                  <c:v>493</c:v>
                </c:pt>
                <c:pt idx="214">
                  <c:v>494</c:v>
                </c:pt>
                <c:pt idx="215">
                  <c:v>495</c:v>
                </c:pt>
                <c:pt idx="216">
                  <c:v>496</c:v>
                </c:pt>
                <c:pt idx="217">
                  <c:v>497</c:v>
                </c:pt>
                <c:pt idx="218">
                  <c:v>498</c:v>
                </c:pt>
                <c:pt idx="219">
                  <c:v>499</c:v>
                </c:pt>
                <c:pt idx="220">
                  <c:v>500</c:v>
                </c:pt>
                <c:pt idx="221">
                  <c:v>501</c:v>
                </c:pt>
                <c:pt idx="222">
                  <c:v>502</c:v>
                </c:pt>
                <c:pt idx="223">
                  <c:v>503</c:v>
                </c:pt>
                <c:pt idx="224">
                  <c:v>504</c:v>
                </c:pt>
                <c:pt idx="225">
                  <c:v>505</c:v>
                </c:pt>
                <c:pt idx="226">
                  <c:v>506</c:v>
                </c:pt>
                <c:pt idx="227">
                  <c:v>507</c:v>
                </c:pt>
                <c:pt idx="228">
                  <c:v>508</c:v>
                </c:pt>
                <c:pt idx="229">
                  <c:v>509</c:v>
                </c:pt>
                <c:pt idx="230">
                  <c:v>510</c:v>
                </c:pt>
                <c:pt idx="231">
                  <c:v>511</c:v>
                </c:pt>
                <c:pt idx="232">
                  <c:v>512</c:v>
                </c:pt>
                <c:pt idx="233">
                  <c:v>513</c:v>
                </c:pt>
                <c:pt idx="234">
                  <c:v>514</c:v>
                </c:pt>
                <c:pt idx="235">
                  <c:v>515</c:v>
                </c:pt>
                <c:pt idx="236">
                  <c:v>516</c:v>
                </c:pt>
                <c:pt idx="237">
                  <c:v>517</c:v>
                </c:pt>
                <c:pt idx="238">
                  <c:v>518</c:v>
                </c:pt>
                <c:pt idx="239">
                  <c:v>519</c:v>
                </c:pt>
                <c:pt idx="240">
                  <c:v>520</c:v>
                </c:pt>
                <c:pt idx="241">
                  <c:v>521</c:v>
                </c:pt>
                <c:pt idx="242">
                  <c:v>522</c:v>
                </c:pt>
                <c:pt idx="243">
                  <c:v>523</c:v>
                </c:pt>
                <c:pt idx="244">
                  <c:v>524</c:v>
                </c:pt>
                <c:pt idx="245">
                  <c:v>525</c:v>
                </c:pt>
                <c:pt idx="246">
                  <c:v>526</c:v>
                </c:pt>
                <c:pt idx="247">
                  <c:v>527</c:v>
                </c:pt>
                <c:pt idx="248">
                  <c:v>528</c:v>
                </c:pt>
                <c:pt idx="249">
                  <c:v>529</c:v>
                </c:pt>
                <c:pt idx="250">
                  <c:v>530</c:v>
                </c:pt>
                <c:pt idx="251">
                  <c:v>531</c:v>
                </c:pt>
                <c:pt idx="252">
                  <c:v>532</c:v>
                </c:pt>
                <c:pt idx="253">
                  <c:v>533</c:v>
                </c:pt>
                <c:pt idx="254">
                  <c:v>534</c:v>
                </c:pt>
                <c:pt idx="255">
                  <c:v>535</c:v>
                </c:pt>
                <c:pt idx="256">
                  <c:v>536</c:v>
                </c:pt>
                <c:pt idx="257">
                  <c:v>537</c:v>
                </c:pt>
                <c:pt idx="258">
                  <c:v>538</c:v>
                </c:pt>
                <c:pt idx="259">
                  <c:v>539</c:v>
                </c:pt>
                <c:pt idx="260">
                  <c:v>540</c:v>
                </c:pt>
                <c:pt idx="261">
                  <c:v>541</c:v>
                </c:pt>
                <c:pt idx="262">
                  <c:v>542</c:v>
                </c:pt>
                <c:pt idx="263">
                  <c:v>543</c:v>
                </c:pt>
                <c:pt idx="264">
                  <c:v>544</c:v>
                </c:pt>
                <c:pt idx="265">
                  <c:v>545</c:v>
                </c:pt>
                <c:pt idx="266">
                  <c:v>546</c:v>
                </c:pt>
                <c:pt idx="267">
                  <c:v>547</c:v>
                </c:pt>
                <c:pt idx="268">
                  <c:v>548</c:v>
                </c:pt>
                <c:pt idx="269">
                  <c:v>549</c:v>
                </c:pt>
                <c:pt idx="270">
                  <c:v>550</c:v>
                </c:pt>
                <c:pt idx="271">
                  <c:v>551</c:v>
                </c:pt>
                <c:pt idx="272">
                  <c:v>552</c:v>
                </c:pt>
                <c:pt idx="273">
                  <c:v>553</c:v>
                </c:pt>
                <c:pt idx="274">
                  <c:v>554</c:v>
                </c:pt>
                <c:pt idx="275">
                  <c:v>555</c:v>
                </c:pt>
                <c:pt idx="276">
                  <c:v>556</c:v>
                </c:pt>
                <c:pt idx="277">
                  <c:v>557</c:v>
                </c:pt>
                <c:pt idx="278">
                  <c:v>558</c:v>
                </c:pt>
                <c:pt idx="279">
                  <c:v>559</c:v>
                </c:pt>
                <c:pt idx="280">
                  <c:v>560</c:v>
                </c:pt>
                <c:pt idx="281">
                  <c:v>561</c:v>
                </c:pt>
                <c:pt idx="282">
                  <c:v>562</c:v>
                </c:pt>
                <c:pt idx="283">
                  <c:v>563</c:v>
                </c:pt>
                <c:pt idx="284">
                  <c:v>564</c:v>
                </c:pt>
                <c:pt idx="285">
                  <c:v>565</c:v>
                </c:pt>
                <c:pt idx="286">
                  <c:v>566</c:v>
                </c:pt>
                <c:pt idx="287">
                  <c:v>567</c:v>
                </c:pt>
                <c:pt idx="288">
                  <c:v>568</c:v>
                </c:pt>
                <c:pt idx="289">
                  <c:v>569</c:v>
                </c:pt>
                <c:pt idx="290">
                  <c:v>570</c:v>
                </c:pt>
                <c:pt idx="291">
                  <c:v>571</c:v>
                </c:pt>
                <c:pt idx="292">
                  <c:v>572</c:v>
                </c:pt>
                <c:pt idx="293">
                  <c:v>573</c:v>
                </c:pt>
                <c:pt idx="294">
                  <c:v>574</c:v>
                </c:pt>
                <c:pt idx="295">
                  <c:v>575</c:v>
                </c:pt>
                <c:pt idx="296">
                  <c:v>576</c:v>
                </c:pt>
                <c:pt idx="297">
                  <c:v>577</c:v>
                </c:pt>
                <c:pt idx="298">
                  <c:v>578</c:v>
                </c:pt>
                <c:pt idx="299">
                  <c:v>579</c:v>
                </c:pt>
                <c:pt idx="300">
                  <c:v>580</c:v>
                </c:pt>
                <c:pt idx="301">
                  <c:v>581</c:v>
                </c:pt>
                <c:pt idx="302">
                  <c:v>582</c:v>
                </c:pt>
                <c:pt idx="303">
                  <c:v>583</c:v>
                </c:pt>
                <c:pt idx="304">
                  <c:v>584</c:v>
                </c:pt>
                <c:pt idx="305">
                  <c:v>585</c:v>
                </c:pt>
                <c:pt idx="306">
                  <c:v>586</c:v>
                </c:pt>
                <c:pt idx="307">
                  <c:v>587</c:v>
                </c:pt>
                <c:pt idx="308">
                  <c:v>588</c:v>
                </c:pt>
                <c:pt idx="309">
                  <c:v>589</c:v>
                </c:pt>
                <c:pt idx="310">
                  <c:v>590</c:v>
                </c:pt>
                <c:pt idx="311">
                  <c:v>591</c:v>
                </c:pt>
                <c:pt idx="312">
                  <c:v>592</c:v>
                </c:pt>
                <c:pt idx="313">
                  <c:v>593</c:v>
                </c:pt>
                <c:pt idx="314">
                  <c:v>594</c:v>
                </c:pt>
                <c:pt idx="315">
                  <c:v>595</c:v>
                </c:pt>
                <c:pt idx="316">
                  <c:v>596</c:v>
                </c:pt>
                <c:pt idx="317">
                  <c:v>597</c:v>
                </c:pt>
                <c:pt idx="318">
                  <c:v>598</c:v>
                </c:pt>
                <c:pt idx="319">
                  <c:v>599</c:v>
                </c:pt>
                <c:pt idx="320">
                  <c:v>600</c:v>
                </c:pt>
                <c:pt idx="321">
                  <c:v>601</c:v>
                </c:pt>
                <c:pt idx="322">
                  <c:v>602</c:v>
                </c:pt>
                <c:pt idx="323">
                  <c:v>603</c:v>
                </c:pt>
                <c:pt idx="324">
                  <c:v>604</c:v>
                </c:pt>
                <c:pt idx="325">
                  <c:v>605</c:v>
                </c:pt>
                <c:pt idx="326">
                  <c:v>606</c:v>
                </c:pt>
                <c:pt idx="327">
                  <c:v>607</c:v>
                </c:pt>
                <c:pt idx="328">
                  <c:v>608</c:v>
                </c:pt>
                <c:pt idx="329">
                  <c:v>609</c:v>
                </c:pt>
                <c:pt idx="330">
                  <c:v>610</c:v>
                </c:pt>
                <c:pt idx="331">
                  <c:v>611</c:v>
                </c:pt>
                <c:pt idx="332">
                  <c:v>612</c:v>
                </c:pt>
                <c:pt idx="333">
                  <c:v>613</c:v>
                </c:pt>
                <c:pt idx="334">
                  <c:v>614</c:v>
                </c:pt>
                <c:pt idx="335">
                  <c:v>615</c:v>
                </c:pt>
                <c:pt idx="336">
                  <c:v>616</c:v>
                </c:pt>
                <c:pt idx="337">
                  <c:v>617</c:v>
                </c:pt>
                <c:pt idx="338">
                  <c:v>618</c:v>
                </c:pt>
                <c:pt idx="339">
                  <c:v>619</c:v>
                </c:pt>
                <c:pt idx="340">
                  <c:v>620</c:v>
                </c:pt>
                <c:pt idx="341">
                  <c:v>621</c:v>
                </c:pt>
                <c:pt idx="342">
                  <c:v>622</c:v>
                </c:pt>
                <c:pt idx="343">
                  <c:v>623</c:v>
                </c:pt>
                <c:pt idx="344">
                  <c:v>624</c:v>
                </c:pt>
                <c:pt idx="345">
                  <c:v>625</c:v>
                </c:pt>
                <c:pt idx="346">
                  <c:v>626</c:v>
                </c:pt>
                <c:pt idx="347">
                  <c:v>627</c:v>
                </c:pt>
                <c:pt idx="348">
                  <c:v>628</c:v>
                </c:pt>
                <c:pt idx="349">
                  <c:v>629</c:v>
                </c:pt>
                <c:pt idx="350">
                  <c:v>630</c:v>
                </c:pt>
                <c:pt idx="351">
                  <c:v>631</c:v>
                </c:pt>
                <c:pt idx="352">
                  <c:v>632</c:v>
                </c:pt>
                <c:pt idx="353">
                  <c:v>633</c:v>
                </c:pt>
                <c:pt idx="354">
                  <c:v>634</c:v>
                </c:pt>
                <c:pt idx="355">
                  <c:v>635</c:v>
                </c:pt>
                <c:pt idx="356">
                  <c:v>636</c:v>
                </c:pt>
                <c:pt idx="357">
                  <c:v>637</c:v>
                </c:pt>
                <c:pt idx="358">
                  <c:v>638</c:v>
                </c:pt>
                <c:pt idx="359">
                  <c:v>639</c:v>
                </c:pt>
                <c:pt idx="360">
                  <c:v>640</c:v>
                </c:pt>
                <c:pt idx="361">
                  <c:v>641</c:v>
                </c:pt>
                <c:pt idx="362">
                  <c:v>642</c:v>
                </c:pt>
                <c:pt idx="363">
                  <c:v>643</c:v>
                </c:pt>
                <c:pt idx="364">
                  <c:v>644</c:v>
                </c:pt>
                <c:pt idx="365">
                  <c:v>645</c:v>
                </c:pt>
                <c:pt idx="366">
                  <c:v>646</c:v>
                </c:pt>
                <c:pt idx="367">
                  <c:v>647</c:v>
                </c:pt>
                <c:pt idx="368">
                  <c:v>648</c:v>
                </c:pt>
                <c:pt idx="369">
                  <c:v>649</c:v>
                </c:pt>
                <c:pt idx="370">
                  <c:v>650</c:v>
                </c:pt>
                <c:pt idx="371">
                  <c:v>651</c:v>
                </c:pt>
                <c:pt idx="372">
                  <c:v>652</c:v>
                </c:pt>
                <c:pt idx="373">
                  <c:v>653</c:v>
                </c:pt>
                <c:pt idx="374">
                  <c:v>654</c:v>
                </c:pt>
                <c:pt idx="375">
                  <c:v>655</c:v>
                </c:pt>
                <c:pt idx="376">
                  <c:v>656</c:v>
                </c:pt>
                <c:pt idx="377">
                  <c:v>657</c:v>
                </c:pt>
                <c:pt idx="378">
                  <c:v>658</c:v>
                </c:pt>
                <c:pt idx="379">
                  <c:v>659</c:v>
                </c:pt>
                <c:pt idx="380">
                  <c:v>660</c:v>
                </c:pt>
                <c:pt idx="381">
                  <c:v>661</c:v>
                </c:pt>
                <c:pt idx="382">
                  <c:v>662</c:v>
                </c:pt>
                <c:pt idx="383">
                  <c:v>663</c:v>
                </c:pt>
                <c:pt idx="384">
                  <c:v>664</c:v>
                </c:pt>
                <c:pt idx="385">
                  <c:v>665</c:v>
                </c:pt>
                <c:pt idx="386">
                  <c:v>666</c:v>
                </c:pt>
                <c:pt idx="387">
                  <c:v>667</c:v>
                </c:pt>
                <c:pt idx="388">
                  <c:v>668</c:v>
                </c:pt>
                <c:pt idx="389">
                  <c:v>669</c:v>
                </c:pt>
                <c:pt idx="390">
                  <c:v>670</c:v>
                </c:pt>
                <c:pt idx="391">
                  <c:v>671</c:v>
                </c:pt>
                <c:pt idx="392">
                  <c:v>672</c:v>
                </c:pt>
                <c:pt idx="393">
                  <c:v>673</c:v>
                </c:pt>
                <c:pt idx="394">
                  <c:v>674</c:v>
                </c:pt>
                <c:pt idx="395">
                  <c:v>675</c:v>
                </c:pt>
                <c:pt idx="396">
                  <c:v>676</c:v>
                </c:pt>
                <c:pt idx="397">
                  <c:v>677</c:v>
                </c:pt>
                <c:pt idx="398">
                  <c:v>678</c:v>
                </c:pt>
                <c:pt idx="399">
                  <c:v>679</c:v>
                </c:pt>
                <c:pt idx="400">
                  <c:v>680</c:v>
                </c:pt>
                <c:pt idx="401">
                  <c:v>681</c:v>
                </c:pt>
                <c:pt idx="402">
                  <c:v>682</c:v>
                </c:pt>
                <c:pt idx="403">
                  <c:v>683</c:v>
                </c:pt>
                <c:pt idx="404">
                  <c:v>684</c:v>
                </c:pt>
                <c:pt idx="405">
                  <c:v>685</c:v>
                </c:pt>
                <c:pt idx="406">
                  <c:v>686</c:v>
                </c:pt>
                <c:pt idx="407">
                  <c:v>687</c:v>
                </c:pt>
                <c:pt idx="408">
                  <c:v>688</c:v>
                </c:pt>
                <c:pt idx="409">
                  <c:v>689</c:v>
                </c:pt>
                <c:pt idx="410">
                  <c:v>690</c:v>
                </c:pt>
                <c:pt idx="411">
                  <c:v>691</c:v>
                </c:pt>
                <c:pt idx="412">
                  <c:v>692</c:v>
                </c:pt>
                <c:pt idx="413">
                  <c:v>693</c:v>
                </c:pt>
                <c:pt idx="414">
                  <c:v>694</c:v>
                </c:pt>
                <c:pt idx="415">
                  <c:v>695</c:v>
                </c:pt>
                <c:pt idx="416">
                  <c:v>696</c:v>
                </c:pt>
                <c:pt idx="417">
                  <c:v>697</c:v>
                </c:pt>
                <c:pt idx="418">
                  <c:v>698</c:v>
                </c:pt>
                <c:pt idx="419">
                  <c:v>699</c:v>
                </c:pt>
                <c:pt idx="420">
                  <c:v>700</c:v>
                </c:pt>
                <c:pt idx="421">
                  <c:v>701</c:v>
                </c:pt>
                <c:pt idx="422">
                  <c:v>702</c:v>
                </c:pt>
                <c:pt idx="423">
                  <c:v>703</c:v>
                </c:pt>
                <c:pt idx="424">
                  <c:v>704</c:v>
                </c:pt>
                <c:pt idx="425">
                  <c:v>705</c:v>
                </c:pt>
                <c:pt idx="426">
                  <c:v>706</c:v>
                </c:pt>
                <c:pt idx="427">
                  <c:v>707</c:v>
                </c:pt>
                <c:pt idx="428">
                  <c:v>708</c:v>
                </c:pt>
                <c:pt idx="429">
                  <c:v>709</c:v>
                </c:pt>
                <c:pt idx="430">
                  <c:v>710</c:v>
                </c:pt>
                <c:pt idx="431">
                  <c:v>711</c:v>
                </c:pt>
                <c:pt idx="432">
                  <c:v>712</c:v>
                </c:pt>
                <c:pt idx="433">
                  <c:v>713</c:v>
                </c:pt>
                <c:pt idx="434">
                  <c:v>714</c:v>
                </c:pt>
                <c:pt idx="435">
                  <c:v>715</c:v>
                </c:pt>
                <c:pt idx="436">
                  <c:v>716</c:v>
                </c:pt>
                <c:pt idx="437">
                  <c:v>717</c:v>
                </c:pt>
                <c:pt idx="438">
                  <c:v>718</c:v>
                </c:pt>
                <c:pt idx="439">
                  <c:v>719</c:v>
                </c:pt>
                <c:pt idx="440">
                  <c:v>720</c:v>
                </c:pt>
                <c:pt idx="441">
                  <c:v>721</c:v>
                </c:pt>
                <c:pt idx="442">
                  <c:v>722</c:v>
                </c:pt>
                <c:pt idx="443">
                  <c:v>723</c:v>
                </c:pt>
                <c:pt idx="444">
                  <c:v>724</c:v>
                </c:pt>
                <c:pt idx="445">
                  <c:v>725</c:v>
                </c:pt>
                <c:pt idx="446">
                  <c:v>726</c:v>
                </c:pt>
                <c:pt idx="447">
                  <c:v>727</c:v>
                </c:pt>
                <c:pt idx="448">
                  <c:v>728</c:v>
                </c:pt>
                <c:pt idx="449">
                  <c:v>729</c:v>
                </c:pt>
                <c:pt idx="450">
                  <c:v>730</c:v>
                </c:pt>
                <c:pt idx="451">
                  <c:v>731</c:v>
                </c:pt>
                <c:pt idx="452">
                  <c:v>732</c:v>
                </c:pt>
                <c:pt idx="453">
                  <c:v>733</c:v>
                </c:pt>
                <c:pt idx="454">
                  <c:v>734</c:v>
                </c:pt>
                <c:pt idx="455">
                  <c:v>735</c:v>
                </c:pt>
                <c:pt idx="456">
                  <c:v>736</c:v>
                </c:pt>
                <c:pt idx="457">
                  <c:v>737</c:v>
                </c:pt>
                <c:pt idx="458">
                  <c:v>738</c:v>
                </c:pt>
                <c:pt idx="459">
                  <c:v>739</c:v>
                </c:pt>
                <c:pt idx="460">
                  <c:v>740</c:v>
                </c:pt>
                <c:pt idx="461">
                  <c:v>741</c:v>
                </c:pt>
                <c:pt idx="462">
                  <c:v>742</c:v>
                </c:pt>
                <c:pt idx="463">
                  <c:v>743</c:v>
                </c:pt>
                <c:pt idx="464">
                  <c:v>744</c:v>
                </c:pt>
                <c:pt idx="465">
                  <c:v>745</c:v>
                </c:pt>
                <c:pt idx="466">
                  <c:v>746</c:v>
                </c:pt>
                <c:pt idx="467">
                  <c:v>747</c:v>
                </c:pt>
                <c:pt idx="468">
                  <c:v>748</c:v>
                </c:pt>
                <c:pt idx="469">
                  <c:v>749</c:v>
                </c:pt>
                <c:pt idx="470">
                  <c:v>750</c:v>
                </c:pt>
                <c:pt idx="471">
                  <c:v>751</c:v>
                </c:pt>
                <c:pt idx="472">
                  <c:v>752</c:v>
                </c:pt>
                <c:pt idx="473">
                  <c:v>753</c:v>
                </c:pt>
                <c:pt idx="474">
                  <c:v>754</c:v>
                </c:pt>
                <c:pt idx="475">
                  <c:v>755</c:v>
                </c:pt>
                <c:pt idx="476">
                  <c:v>756</c:v>
                </c:pt>
                <c:pt idx="477">
                  <c:v>757</c:v>
                </c:pt>
                <c:pt idx="478">
                  <c:v>758</c:v>
                </c:pt>
                <c:pt idx="479">
                  <c:v>759</c:v>
                </c:pt>
                <c:pt idx="480">
                  <c:v>760</c:v>
                </c:pt>
                <c:pt idx="481">
                  <c:v>761</c:v>
                </c:pt>
                <c:pt idx="482">
                  <c:v>762</c:v>
                </c:pt>
                <c:pt idx="483">
                  <c:v>763</c:v>
                </c:pt>
                <c:pt idx="484">
                  <c:v>764</c:v>
                </c:pt>
                <c:pt idx="485">
                  <c:v>765</c:v>
                </c:pt>
                <c:pt idx="486">
                  <c:v>766</c:v>
                </c:pt>
                <c:pt idx="487">
                  <c:v>767</c:v>
                </c:pt>
                <c:pt idx="488">
                  <c:v>768</c:v>
                </c:pt>
                <c:pt idx="489">
                  <c:v>769</c:v>
                </c:pt>
                <c:pt idx="490">
                  <c:v>770</c:v>
                </c:pt>
                <c:pt idx="491">
                  <c:v>771</c:v>
                </c:pt>
                <c:pt idx="492">
                  <c:v>772</c:v>
                </c:pt>
                <c:pt idx="493">
                  <c:v>773</c:v>
                </c:pt>
                <c:pt idx="494">
                  <c:v>774</c:v>
                </c:pt>
                <c:pt idx="495">
                  <c:v>775</c:v>
                </c:pt>
                <c:pt idx="496">
                  <c:v>776</c:v>
                </c:pt>
                <c:pt idx="497">
                  <c:v>777</c:v>
                </c:pt>
                <c:pt idx="498">
                  <c:v>778</c:v>
                </c:pt>
                <c:pt idx="499">
                  <c:v>779</c:v>
                </c:pt>
                <c:pt idx="500">
                  <c:v>780</c:v>
                </c:pt>
                <c:pt idx="501">
                  <c:v>781</c:v>
                </c:pt>
                <c:pt idx="502">
                  <c:v>782</c:v>
                </c:pt>
                <c:pt idx="503">
                  <c:v>783</c:v>
                </c:pt>
                <c:pt idx="504">
                  <c:v>784</c:v>
                </c:pt>
                <c:pt idx="505">
                  <c:v>785</c:v>
                </c:pt>
                <c:pt idx="506">
                  <c:v>786</c:v>
                </c:pt>
                <c:pt idx="507">
                  <c:v>787</c:v>
                </c:pt>
                <c:pt idx="508">
                  <c:v>788</c:v>
                </c:pt>
                <c:pt idx="509">
                  <c:v>789</c:v>
                </c:pt>
                <c:pt idx="510">
                  <c:v>790</c:v>
                </c:pt>
                <c:pt idx="511">
                  <c:v>791</c:v>
                </c:pt>
                <c:pt idx="512">
                  <c:v>792</c:v>
                </c:pt>
                <c:pt idx="513">
                  <c:v>793</c:v>
                </c:pt>
                <c:pt idx="514">
                  <c:v>794</c:v>
                </c:pt>
                <c:pt idx="515">
                  <c:v>795</c:v>
                </c:pt>
                <c:pt idx="516">
                  <c:v>796</c:v>
                </c:pt>
                <c:pt idx="517">
                  <c:v>797</c:v>
                </c:pt>
                <c:pt idx="518">
                  <c:v>798</c:v>
                </c:pt>
                <c:pt idx="519">
                  <c:v>799</c:v>
                </c:pt>
                <c:pt idx="520">
                  <c:v>800</c:v>
                </c:pt>
              </c:numCache>
            </c:numRef>
          </c:xVal>
          <c:yVal>
            <c:numRef>
              <c:f>Data!$N$84:$N$604</c:f>
              <c:numCache>
                <c:formatCode>0.00E+00</c:formatCode>
                <c:ptCount val="52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7.132775430800113E-6</c:v>
                </c:pt>
                <c:pt idx="30">
                  <c:v>6.3256874863000124E-5</c:v>
                </c:pt>
                <c:pt idx="31">
                  <c:v>1.1164094206000224E-4</c:v>
                </c:pt>
                <c:pt idx="32">
                  <c:v>1.8410945503000023E-4</c:v>
                </c:pt>
                <c:pt idx="33">
                  <c:v>2.5987211159000397E-4</c:v>
                </c:pt>
                <c:pt idx="34">
                  <c:v>3.4375116641000475E-4</c:v>
                </c:pt>
                <c:pt idx="35">
                  <c:v>4.2951472517000031E-4</c:v>
                </c:pt>
                <c:pt idx="36">
                  <c:v>4.9854038316000124E-4</c:v>
                </c:pt>
                <c:pt idx="37">
                  <c:v>6.0121963518999983E-4</c:v>
                </c:pt>
                <c:pt idx="38">
                  <c:v>7.3372459785000122E-4</c:v>
                </c:pt>
                <c:pt idx="39">
                  <c:v>9.3067496604001538E-4</c:v>
                </c:pt>
                <c:pt idx="40">
                  <c:v>1.2793070966000061E-3</c:v>
                </c:pt>
                <c:pt idx="41">
                  <c:v>1.8488217794000081E-3</c:v>
                </c:pt>
                <c:pt idx="42">
                  <c:v>2.7741077225000611E-3</c:v>
                </c:pt>
                <c:pt idx="43">
                  <c:v>4.2691670860000534E-3</c:v>
                </c:pt>
                <c:pt idx="44">
                  <c:v>6.6616379307000003E-3</c:v>
                </c:pt>
                <c:pt idx="45">
                  <c:v>1.0071603610000002E-2</c:v>
                </c:pt>
                <c:pt idx="46">
                  <c:v>1.4689309363000023E-2</c:v>
                </c:pt>
                <c:pt idx="47">
                  <c:v>2.0997832110000052E-2</c:v>
                </c:pt>
                <c:pt idx="48">
                  <c:v>2.8366499212999927E-2</c:v>
                </c:pt>
                <c:pt idx="49">
                  <c:v>3.7561950115000041E-2</c:v>
                </c:pt>
                <c:pt idx="50">
                  <c:v>4.7988568760999745E-2</c:v>
                </c:pt>
                <c:pt idx="51">
                  <c:v>6.0284796685999967E-2</c:v>
                </c:pt>
                <c:pt idx="52">
                  <c:v>7.5523678304999994E-2</c:v>
                </c:pt>
                <c:pt idx="53">
                  <c:v>8.9739540809000068E-2</c:v>
                </c:pt>
                <c:pt idx="54">
                  <c:v>0.10589234708000082</c:v>
                </c:pt>
                <c:pt idx="55">
                  <c:v>0.12078626339000002</c:v>
                </c:pt>
                <c:pt idx="56">
                  <c:v>0.13576806826000001</c:v>
                </c:pt>
                <c:pt idx="57">
                  <c:v>0.15084850985000173</c:v>
                </c:pt>
                <c:pt idx="58">
                  <c:v>0.16652497130999988</c:v>
                </c:pt>
                <c:pt idx="59">
                  <c:v>0.18130820815000195</c:v>
                </c:pt>
                <c:pt idx="60">
                  <c:v>0.19696408147000258</c:v>
                </c:pt>
                <c:pt idx="61">
                  <c:v>0.20869077042</c:v>
                </c:pt>
                <c:pt idx="62">
                  <c:v>0.22292178889000044</c:v>
                </c:pt>
                <c:pt idx="63">
                  <c:v>0.23331770413000041</c:v>
                </c:pt>
                <c:pt idx="64">
                  <c:v>0.24749437329000196</c:v>
                </c:pt>
                <c:pt idx="65">
                  <c:v>0.25739378761999998</c:v>
                </c:pt>
                <c:pt idx="66">
                  <c:v>0.27191334138000317</c:v>
                </c:pt>
                <c:pt idx="67">
                  <c:v>0.28311645772000038</c:v>
                </c:pt>
                <c:pt idx="68">
                  <c:v>0.29121526951000032</c:v>
                </c:pt>
                <c:pt idx="69">
                  <c:v>0.30315787607000283</c:v>
                </c:pt>
                <c:pt idx="70">
                  <c:v>0.30989624411000088</c:v>
                </c:pt>
                <c:pt idx="71">
                  <c:v>0.31654367724000504</c:v>
                </c:pt>
                <c:pt idx="72">
                  <c:v>0.32753017029000425</c:v>
                </c:pt>
                <c:pt idx="73">
                  <c:v>0.33047074100000629</c:v>
                </c:pt>
                <c:pt idx="74">
                  <c:v>0.33888572396000843</c:v>
                </c:pt>
                <c:pt idx="75">
                  <c:v>0.34373063184000008</c:v>
                </c:pt>
                <c:pt idx="76">
                  <c:v>0.34811445058000007</c:v>
                </c:pt>
                <c:pt idx="77">
                  <c:v>0.35027573503999998</c:v>
                </c:pt>
                <c:pt idx="78">
                  <c:v>0.35356734972999998</c:v>
                </c:pt>
                <c:pt idx="79">
                  <c:v>0.35317110176000038</c:v>
                </c:pt>
                <c:pt idx="80">
                  <c:v>0.35790366945000363</c:v>
                </c:pt>
                <c:pt idx="81">
                  <c:v>0.36193870014000312</c:v>
                </c:pt>
                <c:pt idx="82">
                  <c:v>0.36538450409000617</c:v>
                </c:pt>
                <c:pt idx="83">
                  <c:v>0.36791710174000425</c:v>
                </c:pt>
                <c:pt idx="84">
                  <c:v>0.36770202423999998</c:v>
                </c:pt>
                <c:pt idx="85">
                  <c:v>0.36936796243000436</c:v>
                </c:pt>
                <c:pt idx="86">
                  <c:v>0.37017062070000317</c:v>
                </c:pt>
                <c:pt idx="87">
                  <c:v>0.37193914458999999</c:v>
                </c:pt>
                <c:pt idx="88">
                  <c:v>0.37509289002000318</c:v>
                </c:pt>
                <c:pt idx="89">
                  <c:v>0.37485768427000504</c:v>
                </c:pt>
                <c:pt idx="90">
                  <c:v>0.37921222800000032</c:v>
                </c:pt>
                <c:pt idx="91">
                  <c:v>0.37781992782000628</c:v>
                </c:pt>
                <c:pt idx="92">
                  <c:v>0.37966987513000566</c:v>
                </c:pt>
                <c:pt idx="93">
                  <c:v>0.38285468871000566</c:v>
                </c:pt>
                <c:pt idx="94">
                  <c:v>0.38026967040000031</c:v>
                </c:pt>
                <c:pt idx="95">
                  <c:v>0.38167282328000646</c:v>
                </c:pt>
                <c:pt idx="96">
                  <c:v>0.38325866953000504</c:v>
                </c:pt>
                <c:pt idx="97">
                  <c:v>0.38580834298000516</c:v>
                </c:pt>
                <c:pt idx="98">
                  <c:v>0.38793542362000188</c:v>
                </c:pt>
                <c:pt idx="99">
                  <c:v>0.38979882026000318</c:v>
                </c:pt>
                <c:pt idx="100">
                  <c:v>0.39210549869000283</c:v>
                </c:pt>
                <c:pt idx="101">
                  <c:v>0.39593125620000008</c:v>
                </c:pt>
                <c:pt idx="102">
                  <c:v>0.39864735036000032</c:v>
                </c:pt>
                <c:pt idx="103">
                  <c:v>0.40064720329999998</c:v>
                </c:pt>
                <c:pt idx="104">
                  <c:v>0.39834448565000635</c:v>
                </c:pt>
                <c:pt idx="105">
                  <c:v>0.40032049080000492</c:v>
                </c:pt>
                <c:pt idx="106">
                  <c:v>0.40231321219000032</c:v>
                </c:pt>
                <c:pt idx="107">
                  <c:v>0.40163518616999994</c:v>
                </c:pt>
                <c:pt idx="108">
                  <c:v>0.40213599394000032</c:v>
                </c:pt>
                <c:pt idx="109">
                  <c:v>0.40354142323999997</c:v>
                </c:pt>
                <c:pt idx="110">
                  <c:v>0.40652767012000363</c:v>
                </c:pt>
                <c:pt idx="111">
                  <c:v>0.41065167313000317</c:v>
                </c:pt>
                <c:pt idx="112">
                  <c:v>0.41141858049000363</c:v>
                </c:pt>
                <c:pt idx="113">
                  <c:v>0.41374396895000032</c:v>
                </c:pt>
                <c:pt idx="114">
                  <c:v>0.41514913369000006</c:v>
                </c:pt>
                <c:pt idx="115">
                  <c:v>0.42038561211000436</c:v>
                </c:pt>
                <c:pt idx="116">
                  <c:v>0.42786181922000516</c:v>
                </c:pt>
                <c:pt idx="117">
                  <c:v>0.43394691141000358</c:v>
                </c:pt>
                <c:pt idx="118">
                  <c:v>0.42503041585000312</c:v>
                </c:pt>
                <c:pt idx="119">
                  <c:v>0.41424451071000001</c:v>
                </c:pt>
                <c:pt idx="120">
                  <c:v>0.40407136312000402</c:v>
                </c:pt>
                <c:pt idx="121">
                  <c:v>0.39293654296000358</c:v>
                </c:pt>
                <c:pt idx="122">
                  <c:v>0.38447847960000708</c:v>
                </c:pt>
                <c:pt idx="123">
                  <c:v>0.37638580013000572</c:v>
                </c:pt>
                <c:pt idx="124">
                  <c:v>0.37301600708000504</c:v>
                </c:pt>
                <c:pt idx="125">
                  <c:v>0.36797960690000425</c:v>
                </c:pt>
                <c:pt idx="126">
                  <c:v>0.36435326061000317</c:v>
                </c:pt>
                <c:pt idx="127">
                  <c:v>0.35871451105000357</c:v>
                </c:pt>
                <c:pt idx="128">
                  <c:v>0.35542631989000639</c:v>
                </c:pt>
                <c:pt idx="129">
                  <c:v>0.35321696382000628</c:v>
                </c:pt>
                <c:pt idx="130">
                  <c:v>0.34706436613000374</c:v>
                </c:pt>
                <c:pt idx="131">
                  <c:v>0.34173612776000006</c:v>
                </c:pt>
                <c:pt idx="132">
                  <c:v>0.33549807674000498</c:v>
                </c:pt>
                <c:pt idx="133">
                  <c:v>0.33077661602000358</c:v>
                </c:pt>
                <c:pt idx="134">
                  <c:v>0.32188532647000317</c:v>
                </c:pt>
                <c:pt idx="135">
                  <c:v>0.31018688099000641</c:v>
                </c:pt>
                <c:pt idx="136">
                  <c:v>0.30263569809000002</c:v>
                </c:pt>
                <c:pt idx="137">
                  <c:v>0.29322802126000397</c:v>
                </c:pt>
                <c:pt idx="138">
                  <c:v>0.28987112491000283</c:v>
                </c:pt>
                <c:pt idx="139">
                  <c:v>0.29177384456</c:v>
                </c:pt>
                <c:pt idx="140">
                  <c:v>0.29064041639000032</c:v>
                </c:pt>
                <c:pt idx="141">
                  <c:v>0.28111833024000032</c:v>
                </c:pt>
                <c:pt idx="142">
                  <c:v>0.26599002463999999</c:v>
                </c:pt>
                <c:pt idx="143">
                  <c:v>0.25495667493000346</c:v>
                </c:pt>
                <c:pt idx="144">
                  <c:v>0.24692688324000173</c:v>
                </c:pt>
                <c:pt idx="145">
                  <c:v>0.23840262713000004</c:v>
                </c:pt>
                <c:pt idx="146">
                  <c:v>0.23072487420999988</c:v>
                </c:pt>
                <c:pt idx="147">
                  <c:v>0.22060858022000002</c:v>
                </c:pt>
                <c:pt idx="148">
                  <c:v>0.21400413605000213</c:v>
                </c:pt>
                <c:pt idx="149">
                  <c:v>0.20548613123000167</c:v>
                </c:pt>
                <c:pt idx="150">
                  <c:v>0.19566434649000153</c:v>
                </c:pt>
                <c:pt idx="151">
                  <c:v>0.18713114292999999</c:v>
                </c:pt>
                <c:pt idx="152">
                  <c:v>0.17736421887000173</c:v>
                </c:pt>
                <c:pt idx="153">
                  <c:v>0.16806677605000003</c:v>
                </c:pt>
                <c:pt idx="154">
                  <c:v>0.1580476086300015</c:v>
                </c:pt>
                <c:pt idx="155">
                  <c:v>0.1459703594400015</c:v>
                </c:pt>
                <c:pt idx="156">
                  <c:v>0.13470433243000232</c:v>
                </c:pt>
                <c:pt idx="157">
                  <c:v>0.12280894335999999</c:v>
                </c:pt>
                <c:pt idx="158">
                  <c:v>0.11186318440000009</c:v>
                </c:pt>
                <c:pt idx="159">
                  <c:v>9.9833152336000208E-2</c:v>
                </c:pt>
                <c:pt idx="160">
                  <c:v>8.8501768502001574E-2</c:v>
                </c:pt>
                <c:pt idx="161">
                  <c:v>7.4094585320000114E-2</c:v>
                </c:pt>
                <c:pt idx="162">
                  <c:v>6.1935655891999987E-2</c:v>
                </c:pt>
                <c:pt idx="163">
                  <c:v>5.1514898111999975E-2</c:v>
                </c:pt>
                <c:pt idx="164">
                  <c:v>4.2018618059000812E-2</c:v>
                </c:pt>
                <c:pt idx="165">
                  <c:v>3.5118464140999978E-2</c:v>
                </c:pt>
                <c:pt idx="166">
                  <c:v>3.0033894920000279E-2</c:v>
                </c:pt>
                <c:pt idx="167">
                  <c:v>2.6134424382999993E-2</c:v>
                </c:pt>
                <c:pt idx="168">
                  <c:v>2.3633516715000052E-2</c:v>
                </c:pt>
                <c:pt idx="169">
                  <c:v>2.2982876223000052E-2</c:v>
                </c:pt>
                <c:pt idx="170">
                  <c:v>2.405572538600001E-2</c:v>
                </c:pt>
                <c:pt idx="171">
                  <c:v>2.3496290924000005E-2</c:v>
                </c:pt>
                <c:pt idx="172">
                  <c:v>2.1406243208000216E-2</c:v>
                </c:pt>
                <c:pt idx="173">
                  <c:v>2.0190479820000003E-2</c:v>
                </c:pt>
                <c:pt idx="174">
                  <c:v>1.8646043586999998E-2</c:v>
                </c:pt>
                <c:pt idx="175">
                  <c:v>1.7638218689000004E-2</c:v>
                </c:pt>
                <c:pt idx="176">
                  <c:v>1.7548992624000004E-2</c:v>
                </c:pt>
                <c:pt idx="177">
                  <c:v>1.7973753348000061E-2</c:v>
                </c:pt>
                <c:pt idx="178">
                  <c:v>1.8452771879000063E-2</c:v>
                </c:pt>
                <c:pt idx="179">
                  <c:v>1.825010120500024E-2</c:v>
                </c:pt>
                <c:pt idx="180">
                  <c:v>1.8052213023999956E-2</c:v>
                </c:pt>
                <c:pt idx="181">
                  <c:v>1.8919330387000013E-2</c:v>
                </c:pt>
                <c:pt idx="182">
                  <c:v>2.1102436502000003E-2</c:v>
                </c:pt>
                <c:pt idx="183">
                  <c:v>2.3071172888000511E-2</c:v>
                </c:pt>
                <c:pt idx="184">
                  <c:v>2.3017599407000006E-2</c:v>
                </c:pt>
                <c:pt idx="185">
                  <c:v>2.2503374502000399E-2</c:v>
                </c:pt>
                <c:pt idx="186">
                  <c:v>2.4613692701000042E-2</c:v>
                </c:pt>
                <c:pt idx="187">
                  <c:v>3.1111955545000052E-2</c:v>
                </c:pt>
                <c:pt idx="188">
                  <c:v>3.6642948657000532E-2</c:v>
                </c:pt>
                <c:pt idx="189">
                  <c:v>3.6707038539000016E-2</c:v>
                </c:pt>
                <c:pt idx="190">
                  <c:v>3.4103689661999996E-2</c:v>
                </c:pt>
                <c:pt idx="191">
                  <c:v>3.2747869540000016E-2</c:v>
                </c:pt>
                <c:pt idx="192">
                  <c:v>3.1897939474000513E-2</c:v>
                </c:pt>
                <c:pt idx="193">
                  <c:v>3.4263403555000002E-2</c:v>
                </c:pt>
                <c:pt idx="194">
                  <c:v>3.9149185738000004E-2</c:v>
                </c:pt>
                <c:pt idx="195">
                  <c:v>3.8900574202E-2</c:v>
                </c:pt>
                <c:pt idx="196">
                  <c:v>3.5146451138999987E-2</c:v>
                </c:pt>
                <c:pt idx="197">
                  <c:v>3.3596744233999998E-2</c:v>
                </c:pt>
                <c:pt idx="198">
                  <c:v>3.3550415926000006E-2</c:v>
                </c:pt>
                <c:pt idx="199">
                  <c:v>3.3911615365000002E-2</c:v>
                </c:pt>
                <c:pt idx="200">
                  <c:v>3.4872635698000046E-2</c:v>
                </c:pt>
                <c:pt idx="201">
                  <c:v>3.7542522198000007E-2</c:v>
                </c:pt>
                <c:pt idx="202">
                  <c:v>4.0523969345999986E-2</c:v>
                </c:pt>
                <c:pt idx="203">
                  <c:v>4.0579891219000006E-2</c:v>
                </c:pt>
                <c:pt idx="204">
                  <c:v>3.9135454290999988E-2</c:v>
                </c:pt>
                <c:pt idx="205">
                  <c:v>3.7323212971000455E-2</c:v>
                </c:pt>
                <c:pt idx="206">
                  <c:v>3.4924945951000007E-2</c:v>
                </c:pt>
                <c:pt idx="207">
                  <c:v>3.2045241501000514E-2</c:v>
                </c:pt>
                <c:pt idx="208">
                  <c:v>2.9358491008999978E-2</c:v>
                </c:pt>
                <c:pt idx="209">
                  <c:v>2.7559776496000096E-2</c:v>
                </c:pt>
                <c:pt idx="210">
                  <c:v>2.6168179033999997E-2</c:v>
                </c:pt>
                <c:pt idx="211">
                  <c:v>2.4776876516000051E-2</c:v>
                </c:pt>
                <c:pt idx="212">
                  <c:v>2.4190032112000003E-2</c:v>
                </c:pt>
                <c:pt idx="213">
                  <c:v>2.4882646163000014E-2</c:v>
                </c:pt>
                <c:pt idx="214">
                  <c:v>2.3596734015999998E-2</c:v>
                </c:pt>
                <c:pt idx="215">
                  <c:v>1.9681909567000232E-2</c:v>
                </c:pt>
                <c:pt idx="216">
                  <c:v>1.6534210993000002E-2</c:v>
                </c:pt>
                <c:pt idx="217">
                  <c:v>1.4400770835000081E-2</c:v>
                </c:pt>
                <c:pt idx="218">
                  <c:v>1.2756401988E-2</c:v>
                </c:pt>
                <c:pt idx="219">
                  <c:v>1.1365509401000203E-2</c:v>
                </c:pt>
                <c:pt idx="220">
                  <c:v>1.0272298979999791E-2</c:v>
                </c:pt>
                <c:pt idx="221">
                  <c:v>9.3898407391001647E-3</c:v>
                </c:pt>
                <c:pt idx="222">
                  <c:v>8.5514507044000248E-3</c:v>
                </c:pt>
                <c:pt idx="223">
                  <c:v>7.9206028065999991E-3</c:v>
                </c:pt>
                <c:pt idx="224">
                  <c:v>7.2668935559000777E-3</c:v>
                </c:pt>
                <c:pt idx="225">
                  <c:v>6.7346481486000994E-3</c:v>
                </c:pt>
                <c:pt idx="226">
                  <c:v>6.2143690136000906E-3</c:v>
                </c:pt>
                <c:pt idx="227">
                  <c:v>5.8543243544000008E-3</c:v>
                </c:pt>
                <c:pt idx="228">
                  <c:v>5.5581773739000022E-3</c:v>
                </c:pt>
                <c:pt idx="229">
                  <c:v>5.3422135459000033E-3</c:v>
                </c:pt>
                <c:pt idx="230">
                  <c:v>5.1327327268000014E-3</c:v>
                </c:pt>
                <c:pt idx="231">
                  <c:v>5.0662123706000034E-3</c:v>
                </c:pt>
                <c:pt idx="232">
                  <c:v>4.9988038999000534E-3</c:v>
                </c:pt>
                <c:pt idx="233">
                  <c:v>4.9601828957000034E-3</c:v>
                </c:pt>
                <c:pt idx="234">
                  <c:v>4.8903480007000642E-3</c:v>
                </c:pt>
                <c:pt idx="235">
                  <c:v>4.8497062945000776E-3</c:v>
                </c:pt>
                <c:pt idx="236">
                  <c:v>4.897144144800001E-3</c:v>
                </c:pt>
                <c:pt idx="237">
                  <c:v>4.9077433121000906E-3</c:v>
                </c:pt>
                <c:pt idx="238">
                  <c:v>4.9135543287999956E-3</c:v>
                </c:pt>
                <c:pt idx="239">
                  <c:v>4.9359215842000861E-3</c:v>
                </c:pt>
                <c:pt idx="240">
                  <c:v>4.9795079166000114E-3</c:v>
                </c:pt>
                <c:pt idx="241">
                  <c:v>5.0856281311000891E-3</c:v>
                </c:pt>
                <c:pt idx="242">
                  <c:v>5.0978244086000001E-3</c:v>
                </c:pt>
                <c:pt idx="243">
                  <c:v>5.0539139572E-3</c:v>
                </c:pt>
                <c:pt idx="244">
                  <c:v>5.1071006787999675E-3</c:v>
                </c:pt>
                <c:pt idx="245">
                  <c:v>5.1535055477999765E-3</c:v>
                </c:pt>
                <c:pt idx="246">
                  <c:v>5.1567303066999996E-3</c:v>
                </c:pt>
                <c:pt idx="247">
                  <c:v>5.1377937798000014E-3</c:v>
                </c:pt>
                <c:pt idx="248">
                  <c:v>5.1511877559000004E-3</c:v>
                </c:pt>
                <c:pt idx="249">
                  <c:v>5.1519339079999955E-3</c:v>
                </c:pt>
                <c:pt idx="250">
                  <c:v>5.1267603686000014E-3</c:v>
                </c:pt>
                <c:pt idx="251">
                  <c:v>5.0873141890000013E-3</c:v>
                </c:pt>
                <c:pt idx="252">
                  <c:v>5.0487276320000133E-3</c:v>
                </c:pt>
                <c:pt idx="253">
                  <c:v>5.0137905661999955E-3</c:v>
                </c:pt>
                <c:pt idx="254">
                  <c:v>4.9933304243000819E-3</c:v>
                </c:pt>
                <c:pt idx="255">
                  <c:v>4.9828599555999994E-3</c:v>
                </c:pt>
                <c:pt idx="256">
                  <c:v>4.9231695670999996E-3</c:v>
                </c:pt>
                <c:pt idx="257">
                  <c:v>4.873627786100094E-3</c:v>
                </c:pt>
                <c:pt idx="258">
                  <c:v>4.8900622799000013E-3</c:v>
                </c:pt>
                <c:pt idx="259">
                  <c:v>4.8823237264000114E-3</c:v>
                </c:pt>
                <c:pt idx="260">
                  <c:v>4.8578507057000014E-3</c:v>
                </c:pt>
                <c:pt idx="261">
                  <c:v>4.8753099012000534E-3</c:v>
                </c:pt>
                <c:pt idx="262">
                  <c:v>4.9986926645000859E-3</c:v>
                </c:pt>
                <c:pt idx="263">
                  <c:v>5.2774641938000957E-3</c:v>
                </c:pt>
                <c:pt idx="264">
                  <c:v>5.4966671304001241E-3</c:v>
                </c:pt>
                <c:pt idx="265">
                  <c:v>5.4739576711000104E-3</c:v>
                </c:pt>
                <c:pt idx="266">
                  <c:v>5.5720829211000104E-3</c:v>
                </c:pt>
                <c:pt idx="267">
                  <c:v>5.4163138099000124E-3</c:v>
                </c:pt>
                <c:pt idx="268">
                  <c:v>5.0684771432000023E-3</c:v>
                </c:pt>
                <c:pt idx="269">
                  <c:v>5.0920439457000652E-3</c:v>
                </c:pt>
                <c:pt idx="270">
                  <c:v>5.1375766901000011E-3</c:v>
                </c:pt>
                <c:pt idx="271">
                  <c:v>5.2671464781999956E-3</c:v>
                </c:pt>
                <c:pt idx="272">
                  <c:v>5.3459861777999775E-3</c:v>
                </c:pt>
                <c:pt idx="273">
                  <c:v>5.5234448242000014E-3</c:v>
                </c:pt>
                <c:pt idx="274">
                  <c:v>5.6344980014000024E-3</c:v>
                </c:pt>
                <c:pt idx="275">
                  <c:v>5.7442208251000434E-3</c:v>
                </c:pt>
                <c:pt idx="276">
                  <c:v>5.939275400600132E-3</c:v>
                </c:pt>
                <c:pt idx="277">
                  <c:v>6.0907165589999855E-3</c:v>
                </c:pt>
                <c:pt idx="278">
                  <c:v>6.3541752460999296E-3</c:v>
                </c:pt>
                <c:pt idx="279">
                  <c:v>6.5479633522000534E-3</c:v>
                </c:pt>
                <c:pt idx="280">
                  <c:v>6.7911199408000134E-3</c:v>
                </c:pt>
                <c:pt idx="281">
                  <c:v>7.0303614724001127E-3</c:v>
                </c:pt>
                <c:pt idx="282">
                  <c:v>7.3263008586999965E-3</c:v>
                </c:pt>
                <c:pt idx="283">
                  <c:v>7.5087533497000631E-3</c:v>
                </c:pt>
                <c:pt idx="284">
                  <c:v>7.743333825300092E-3</c:v>
                </c:pt>
                <c:pt idx="285">
                  <c:v>8.0226554831000028E-3</c:v>
                </c:pt>
                <c:pt idx="286">
                  <c:v>8.3317831690000021E-3</c:v>
                </c:pt>
                <c:pt idx="287">
                  <c:v>8.5801457482000028E-3</c:v>
                </c:pt>
                <c:pt idx="288">
                  <c:v>8.8485278750000205E-3</c:v>
                </c:pt>
                <c:pt idx="289">
                  <c:v>9.0955702924001396E-3</c:v>
                </c:pt>
                <c:pt idx="290">
                  <c:v>9.3275811256000266E-3</c:v>
                </c:pt>
                <c:pt idx="291">
                  <c:v>9.5424847871000747E-3</c:v>
                </c:pt>
                <c:pt idx="292">
                  <c:v>9.7103472931000228E-3</c:v>
                </c:pt>
                <c:pt idx="293">
                  <c:v>9.886457637800234E-3</c:v>
                </c:pt>
                <c:pt idx="294">
                  <c:v>1.0165083073E-2</c:v>
                </c:pt>
                <c:pt idx="295">
                  <c:v>1.0384738871999998E-2</c:v>
                </c:pt>
                <c:pt idx="296">
                  <c:v>1.0570662670999846E-2</c:v>
                </c:pt>
                <c:pt idx="297">
                  <c:v>1.0851345435000001E-2</c:v>
                </c:pt>
                <c:pt idx="298">
                  <c:v>1.0975384526E-2</c:v>
                </c:pt>
                <c:pt idx="299">
                  <c:v>1.1157805769000174E-2</c:v>
                </c:pt>
                <c:pt idx="300">
                  <c:v>1.1402040123E-2</c:v>
                </c:pt>
                <c:pt idx="301">
                  <c:v>1.1569688159000001E-2</c:v>
                </c:pt>
                <c:pt idx="302">
                  <c:v>1.1734914988999996E-2</c:v>
                </c:pt>
                <c:pt idx="303">
                  <c:v>1.1896117247000187E-2</c:v>
                </c:pt>
                <c:pt idx="304">
                  <c:v>1.2058846706999844E-2</c:v>
                </c:pt>
                <c:pt idx="305">
                  <c:v>1.2193433564E-2</c:v>
                </c:pt>
                <c:pt idx="306">
                  <c:v>1.2243730398000146E-2</c:v>
                </c:pt>
                <c:pt idx="307">
                  <c:v>1.240661687199978E-2</c:v>
                </c:pt>
                <c:pt idx="308">
                  <c:v>1.2494085546000021E-2</c:v>
                </c:pt>
                <c:pt idx="309">
                  <c:v>1.2623428979000005E-2</c:v>
                </c:pt>
                <c:pt idx="310">
                  <c:v>1.2736172405000001E-2</c:v>
                </c:pt>
                <c:pt idx="311">
                  <c:v>1.2695492727999866E-2</c:v>
                </c:pt>
                <c:pt idx="312">
                  <c:v>1.2786497057000001E-2</c:v>
                </c:pt>
                <c:pt idx="313">
                  <c:v>1.2874048791000001E-2</c:v>
                </c:pt>
                <c:pt idx="314">
                  <c:v>1.2860263427999992E-2</c:v>
                </c:pt>
                <c:pt idx="315">
                  <c:v>1.2811924674999999E-2</c:v>
                </c:pt>
                <c:pt idx="316">
                  <c:v>1.2732543557999998E-2</c:v>
                </c:pt>
                <c:pt idx="317">
                  <c:v>1.2721975782000145E-2</c:v>
                </c:pt>
                <c:pt idx="318">
                  <c:v>1.2712945336000002E-2</c:v>
                </c:pt>
                <c:pt idx="319">
                  <c:v>1.2697919168E-2</c:v>
                </c:pt>
                <c:pt idx="320">
                  <c:v>1.2779814419999999E-2</c:v>
                </c:pt>
                <c:pt idx="321">
                  <c:v>1.2765868621000103E-2</c:v>
                </c:pt>
                <c:pt idx="322">
                  <c:v>1.2829618956999864E-2</c:v>
                </c:pt>
                <c:pt idx="323">
                  <c:v>1.2889309515000023E-2</c:v>
                </c:pt>
                <c:pt idx="324">
                  <c:v>1.2951497507999996E-2</c:v>
                </c:pt>
                <c:pt idx="325">
                  <c:v>1.3092938811E-2</c:v>
                </c:pt>
                <c:pt idx="326">
                  <c:v>1.3128003110000001E-2</c:v>
                </c:pt>
                <c:pt idx="327">
                  <c:v>1.3293173244000237E-2</c:v>
                </c:pt>
                <c:pt idx="328">
                  <c:v>1.3465180842000192E-2</c:v>
                </c:pt>
                <c:pt idx="329">
                  <c:v>1.3845750437000176E-2</c:v>
                </c:pt>
                <c:pt idx="330">
                  <c:v>1.4757833923999847E-2</c:v>
                </c:pt>
                <c:pt idx="331">
                  <c:v>1.5252840132E-2</c:v>
                </c:pt>
                <c:pt idx="332">
                  <c:v>1.4916091342000021E-2</c:v>
                </c:pt>
                <c:pt idx="333">
                  <c:v>1.4665752650000002E-2</c:v>
                </c:pt>
                <c:pt idx="334">
                  <c:v>1.4706179195000208E-2</c:v>
                </c:pt>
                <c:pt idx="335">
                  <c:v>1.4701403321000003E-2</c:v>
                </c:pt>
                <c:pt idx="336">
                  <c:v>1.4763135091000175E-2</c:v>
                </c:pt>
                <c:pt idx="337">
                  <c:v>1.4921316262000007E-2</c:v>
                </c:pt>
                <c:pt idx="338">
                  <c:v>1.5153942877999762E-2</c:v>
                </c:pt>
                <c:pt idx="339">
                  <c:v>1.5253439518000103E-2</c:v>
                </c:pt>
                <c:pt idx="340">
                  <c:v>1.5297033955999852E-2</c:v>
                </c:pt>
                <c:pt idx="341">
                  <c:v>1.5231763585999996E-2</c:v>
                </c:pt>
                <c:pt idx="342">
                  <c:v>1.5037295421999837E-2</c:v>
                </c:pt>
                <c:pt idx="343">
                  <c:v>1.4901167805000021E-2</c:v>
                </c:pt>
                <c:pt idx="344">
                  <c:v>1.4725146613000003E-2</c:v>
                </c:pt>
                <c:pt idx="345">
                  <c:v>1.4550471857000001E-2</c:v>
                </c:pt>
                <c:pt idx="346">
                  <c:v>1.4343334785000003E-2</c:v>
                </c:pt>
                <c:pt idx="347">
                  <c:v>1.4174642091999805E-2</c:v>
                </c:pt>
                <c:pt idx="348">
                  <c:v>1.4088468257000003E-2</c:v>
                </c:pt>
                <c:pt idx="349">
                  <c:v>1.3982810847000217E-2</c:v>
                </c:pt>
                <c:pt idx="350">
                  <c:v>1.3931309951000007E-2</c:v>
                </c:pt>
                <c:pt idx="351">
                  <c:v>1.3949565905000133E-2</c:v>
                </c:pt>
                <c:pt idx="352">
                  <c:v>1.3770967244000133E-2</c:v>
                </c:pt>
                <c:pt idx="353">
                  <c:v>1.3472923902E-2</c:v>
                </c:pt>
                <c:pt idx="354">
                  <c:v>1.3103196958E-2</c:v>
                </c:pt>
                <c:pt idx="355">
                  <c:v>1.2764224208000148E-2</c:v>
                </c:pt>
                <c:pt idx="356">
                  <c:v>1.2417888005999999E-2</c:v>
                </c:pt>
                <c:pt idx="357">
                  <c:v>1.2131742158999809E-2</c:v>
                </c:pt>
                <c:pt idx="358">
                  <c:v>1.1872071961000158E-2</c:v>
                </c:pt>
                <c:pt idx="359">
                  <c:v>1.1560752512000141E-2</c:v>
                </c:pt>
                <c:pt idx="360">
                  <c:v>1.1298956860999998E-2</c:v>
                </c:pt>
                <c:pt idx="361">
                  <c:v>1.0990544446000146E-2</c:v>
                </c:pt>
                <c:pt idx="362">
                  <c:v>1.0702687956999996E-2</c:v>
                </c:pt>
                <c:pt idx="363">
                  <c:v>1.0390996288999994E-2</c:v>
                </c:pt>
                <c:pt idx="364">
                  <c:v>1.0093901835E-2</c:v>
                </c:pt>
                <c:pt idx="365">
                  <c:v>1.0000207475999978E-2</c:v>
                </c:pt>
                <c:pt idx="366">
                  <c:v>9.8203853094000568E-3</c:v>
                </c:pt>
                <c:pt idx="367">
                  <c:v>9.7406027845000007E-3</c:v>
                </c:pt>
                <c:pt idx="368">
                  <c:v>9.5527242697001809E-3</c:v>
                </c:pt>
                <c:pt idx="369">
                  <c:v>9.0345165811000026E-3</c:v>
                </c:pt>
                <c:pt idx="370">
                  <c:v>8.4306796677000046E-3</c:v>
                </c:pt>
                <c:pt idx="371">
                  <c:v>7.8906844035999991E-3</c:v>
                </c:pt>
                <c:pt idx="372">
                  <c:v>7.3867679674000123E-3</c:v>
                </c:pt>
                <c:pt idx="373">
                  <c:v>7.0275509040000003E-3</c:v>
                </c:pt>
                <c:pt idx="374">
                  <c:v>6.7168165050000032E-3</c:v>
                </c:pt>
                <c:pt idx="375">
                  <c:v>6.2774015042000534E-3</c:v>
                </c:pt>
                <c:pt idx="376">
                  <c:v>6.0128677637000544E-3</c:v>
                </c:pt>
                <c:pt idx="377">
                  <c:v>5.7880680539000931E-3</c:v>
                </c:pt>
                <c:pt idx="378">
                  <c:v>5.5588159781999845E-3</c:v>
                </c:pt>
                <c:pt idx="379">
                  <c:v>5.3242441971999999E-3</c:v>
                </c:pt>
                <c:pt idx="380">
                  <c:v>5.131467615500096E-3</c:v>
                </c:pt>
                <c:pt idx="381">
                  <c:v>4.9778403827000954E-3</c:v>
                </c:pt>
                <c:pt idx="382">
                  <c:v>4.7817788908000895E-3</c:v>
                </c:pt>
                <c:pt idx="383">
                  <c:v>4.6133672802000534E-3</c:v>
                </c:pt>
                <c:pt idx="384">
                  <c:v>4.474223680100118E-3</c:v>
                </c:pt>
                <c:pt idx="385">
                  <c:v>4.3518695878000434E-3</c:v>
                </c:pt>
                <c:pt idx="386">
                  <c:v>4.2738362725999995E-3</c:v>
                </c:pt>
                <c:pt idx="387">
                  <c:v>4.1541952406999655E-3</c:v>
                </c:pt>
                <c:pt idx="388">
                  <c:v>4.0076914958001074E-3</c:v>
                </c:pt>
                <c:pt idx="389">
                  <c:v>3.8759785341000003E-3</c:v>
                </c:pt>
                <c:pt idx="390">
                  <c:v>3.7456850553000392E-3</c:v>
                </c:pt>
                <c:pt idx="391">
                  <c:v>3.7121848419000643E-3</c:v>
                </c:pt>
                <c:pt idx="392">
                  <c:v>3.6601209889000671E-3</c:v>
                </c:pt>
                <c:pt idx="393">
                  <c:v>3.6065379640000421E-3</c:v>
                </c:pt>
                <c:pt idx="394">
                  <c:v>3.559234830400027E-3</c:v>
                </c:pt>
                <c:pt idx="395">
                  <c:v>3.5412193608000252E-3</c:v>
                </c:pt>
                <c:pt idx="396">
                  <c:v>3.4321545561000317E-3</c:v>
                </c:pt>
                <c:pt idx="397">
                  <c:v>3.3915346955000016E-3</c:v>
                </c:pt>
                <c:pt idx="398">
                  <c:v>3.3394846377000002E-3</c:v>
                </c:pt>
                <c:pt idx="399">
                  <c:v>3.3434776890000012E-3</c:v>
                </c:pt>
                <c:pt idx="400">
                  <c:v>3.4019689025000005E-3</c:v>
                </c:pt>
                <c:pt idx="401">
                  <c:v>3.5725941458000397E-3</c:v>
                </c:pt>
                <c:pt idx="402">
                  <c:v>4.0562882805000545E-3</c:v>
                </c:pt>
                <c:pt idx="403">
                  <c:v>4.4718399571000104E-3</c:v>
                </c:pt>
                <c:pt idx="404">
                  <c:v>4.4545524140000023E-3</c:v>
                </c:pt>
                <c:pt idx="405">
                  <c:v>4.3650903392E-3</c:v>
                </c:pt>
                <c:pt idx="406">
                  <c:v>4.5115667157000754E-3</c:v>
                </c:pt>
                <c:pt idx="407">
                  <c:v>4.7988618521000014E-3</c:v>
                </c:pt>
                <c:pt idx="408">
                  <c:v>5.1789523297999995E-3</c:v>
                </c:pt>
                <c:pt idx="409">
                  <c:v>5.4060469212000818E-3</c:v>
                </c:pt>
                <c:pt idx="410">
                  <c:v>5.3581239797000002E-3</c:v>
                </c:pt>
                <c:pt idx="411">
                  <c:v>5.1432881317000434E-3</c:v>
                </c:pt>
                <c:pt idx="412">
                  <c:v>4.9435118698999865E-3</c:v>
                </c:pt>
                <c:pt idx="413">
                  <c:v>4.8310042288000014E-3</c:v>
                </c:pt>
                <c:pt idx="414">
                  <c:v>4.7607864297999998E-3</c:v>
                </c:pt>
                <c:pt idx="415">
                  <c:v>4.8416938884000924E-3</c:v>
                </c:pt>
                <c:pt idx="416">
                  <c:v>4.9968921571000623E-3</c:v>
                </c:pt>
                <c:pt idx="417">
                  <c:v>5.2609020997000334E-3</c:v>
                </c:pt>
                <c:pt idx="418">
                  <c:v>5.4627365764999755E-3</c:v>
                </c:pt>
                <c:pt idx="419">
                  <c:v>5.5954283037000134E-3</c:v>
                </c:pt>
                <c:pt idx="420">
                  <c:v>5.6740056900999999E-3</c:v>
                </c:pt>
                <c:pt idx="421">
                  <c:v>5.8040093024000023E-3</c:v>
                </c:pt>
                <c:pt idx="422">
                  <c:v>5.9635127307999993E-3</c:v>
                </c:pt>
                <c:pt idx="423">
                  <c:v>6.2079095812000587E-3</c:v>
                </c:pt>
                <c:pt idx="424">
                  <c:v>6.5467951243000999E-3</c:v>
                </c:pt>
                <c:pt idx="425">
                  <c:v>6.983956861500001E-3</c:v>
                </c:pt>
                <c:pt idx="426">
                  <c:v>7.5990622115000945E-3</c:v>
                </c:pt>
                <c:pt idx="427">
                  <c:v>8.2642563793000248E-3</c:v>
                </c:pt>
                <c:pt idx="428">
                  <c:v>9.2120253057000022E-3</c:v>
                </c:pt>
                <c:pt idx="429">
                  <c:v>1.0330642401999804E-2</c:v>
                </c:pt>
                <c:pt idx="430">
                  <c:v>1.1341272536999999E-2</c:v>
                </c:pt>
                <c:pt idx="431">
                  <c:v>1.1743077795000242E-2</c:v>
                </c:pt>
                <c:pt idx="432">
                  <c:v>1.1472105088000183E-2</c:v>
                </c:pt>
                <c:pt idx="433">
                  <c:v>1.0865900444000001E-2</c:v>
                </c:pt>
                <c:pt idx="434">
                  <c:v>1.0423217564E-2</c:v>
                </c:pt>
                <c:pt idx="435">
                  <c:v>1.0196141967E-2</c:v>
                </c:pt>
                <c:pt idx="436">
                  <c:v>1.0024905651000003E-2</c:v>
                </c:pt>
                <c:pt idx="437">
                  <c:v>9.9044315252001455E-3</c:v>
                </c:pt>
                <c:pt idx="438">
                  <c:v>9.788457482100001E-3</c:v>
                </c:pt>
                <c:pt idx="439">
                  <c:v>9.6615628014000247E-3</c:v>
                </c:pt>
                <c:pt idx="440">
                  <c:v>9.6433464571000025E-3</c:v>
                </c:pt>
                <c:pt idx="441">
                  <c:v>9.7422384314000028E-3</c:v>
                </c:pt>
                <c:pt idx="442">
                  <c:v>9.9181740729000021E-3</c:v>
                </c:pt>
                <c:pt idx="443">
                  <c:v>1.0140599540000151E-2</c:v>
                </c:pt>
                <c:pt idx="444">
                  <c:v>1.0498141327999998E-2</c:v>
                </c:pt>
                <c:pt idx="445">
                  <c:v>1.1013577880000043E-2</c:v>
                </c:pt>
                <c:pt idx="446">
                  <c:v>1.1821615859000137E-2</c:v>
                </c:pt>
                <c:pt idx="447">
                  <c:v>1.2696202176999757E-2</c:v>
                </c:pt>
                <c:pt idx="448">
                  <c:v>1.2992964322999996E-2</c:v>
                </c:pt>
                <c:pt idx="449">
                  <c:v>1.3018944943999852E-2</c:v>
                </c:pt>
                <c:pt idx="450">
                  <c:v>1.3748284654000041E-2</c:v>
                </c:pt>
                <c:pt idx="451">
                  <c:v>1.4878557353000001E-2</c:v>
                </c:pt>
                <c:pt idx="452">
                  <c:v>1.5294256490000002E-2</c:v>
                </c:pt>
                <c:pt idx="453">
                  <c:v>1.4604329035000146E-2</c:v>
                </c:pt>
                <c:pt idx="454">
                  <c:v>1.3295763558999998E-2</c:v>
                </c:pt>
                <c:pt idx="455">
                  <c:v>1.2096571743000183E-2</c:v>
                </c:pt>
                <c:pt idx="456">
                  <c:v>1.1874852401000001E-2</c:v>
                </c:pt>
                <c:pt idx="457">
                  <c:v>1.2258109374999998E-2</c:v>
                </c:pt>
                <c:pt idx="458">
                  <c:v>1.3105264081000002E-2</c:v>
                </c:pt>
                <c:pt idx="459">
                  <c:v>1.3849951333000158E-2</c:v>
                </c:pt>
                <c:pt idx="460">
                  <c:v>1.4071140386E-2</c:v>
                </c:pt>
                <c:pt idx="461">
                  <c:v>1.3556840613000143E-2</c:v>
                </c:pt>
                <c:pt idx="462">
                  <c:v>1.2746560571E-2</c:v>
                </c:pt>
                <c:pt idx="463">
                  <c:v>1.1894501760000217E-2</c:v>
                </c:pt>
                <c:pt idx="464">
                  <c:v>1.1227446714000021E-2</c:v>
                </c:pt>
                <c:pt idx="465">
                  <c:v>1.0748518290000177E-2</c:v>
                </c:pt>
                <c:pt idx="466">
                  <c:v>1.0648201232000021E-2</c:v>
                </c:pt>
                <c:pt idx="467">
                  <c:v>1.1042154523000001E-2</c:v>
                </c:pt>
                <c:pt idx="468">
                  <c:v>1.1396233012E-2</c:v>
                </c:pt>
                <c:pt idx="469">
                  <c:v>1.1176617975999786E-2</c:v>
                </c:pt>
                <c:pt idx="470">
                  <c:v>1.0899607319000007E-2</c:v>
                </c:pt>
                <c:pt idx="471">
                  <c:v>1.0745274129000002E-2</c:v>
                </c:pt>
                <c:pt idx="472">
                  <c:v>1.0526149707000021E-2</c:v>
                </c:pt>
                <c:pt idx="473">
                  <c:v>1.0172315535999996E-2</c:v>
                </c:pt>
                <c:pt idx="474">
                  <c:v>1.0030688010999999E-2</c:v>
                </c:pt>
                <c:pt idx="475">
                  <c:v>1.0089121930000007E-2</c:v>
                </c:pt>
                <c:pt idx="476">
                  <c:v>1.0314244853999795E-2</c:v>
                </c:pt>
                <c:pt idx="477">
                  <c:v>1.0835000821E-2</c:v>
                </c:pt>
                <c:pt idx="478">
                  <c:v>1.1196805852000001E-2</c:v>
                </c:pt>
                <c:pt idx="479">
                  <c:v>1.1477749504E-2</c:v>
                </c:pt>
                <c:pt idx="480">
                  <c:v>1.3634691613000021E-2</c:v>
                </c:pt>
                <c:pt idx="481">
                  <c:v>2.1391890332999999E-2</c:v>
                </c:pt>
                <c:pt idx="482">
                  <c:v>2.4596287598000002E-2</c:v>
                </c:pt>
                <c:pt idx="483">
                  <c:v>1.8245583688000232E-2</c:v>
                </c:pt>
                <c:pt idx="484">
                  <c:v>1.1740545792000259E-2</c:v>
                </c:pt>
                <c:pt idx="485">
                  <c:v>9.3835926931001845E-3</c:v>
                </c:pt>
                <c:pt idx="486">
                  <c:v>8.1631999147001415E-3</c:v>
                </c:pt>
                <c:pt idx="487">
                  <c:v>7.4601828282000009E-3</c:v>
                </c:pt>
                <c:pt idx="488">
                  <c:v>6.9009973862000648E-3</c:v>
                </c:pt>
                <c:pt idx="489">
                  <c:v>6.5121201593000104E-3</c:v>
                </c:pt>
                <c:pt idx="490">
                  <c:v>6.1641539527E-3</c:v>
                </c:pt>
                <c:pt idx="491">
                  <c:v>5.8941145841999946E-3</c:v>
                </c:pt>
                <c:pt idx="492">
                  <c:v>5.5346820937000824E-3</c:v>
                </c:pt>
                <c:pt idx="493">
                  <c:v>5.2623108112000005E-3</c:v>
                </c:pt>
                <c:pt idx="494">
                  <c:v>5.0306311389000623E-3</c:v>
                </c:pt>
                <c:pt idx="495">
                  <c:v>4.9521861845000124E-3</c:v>
                </c:pt>
                <c:pt idx="496">
                  <c:v>4.8248178768998968E-3</c:v>
                </c:pt>
                <c:pt idx="497">
                  <c:v>4.7648721561999955E-3</c:v>
                </c:pt>
                <c:pt idx="498">
                  <c:v>4.8904573259999995E-3</c:v>
                </c:pt>
                <c:pt idx="499">
                  <c:v>5.1771364200000015E-3</c:v>
                </c:pt>
                <c:pt idx="500">
                  <c:v>5.3258787876000104E-3</c:v>
                </c:pt>
                <c:pt idx="501">
                  <c:v>5.3448147566999655E-3</c:v>
                </c:pt>
                <c:pt idx="502">
                  <c:v>5.2844667022000653E-3</c:v>
                </c:pt>
                <c:pt idx="503">
                  <c:v>5.3403961009000703E-3</c:v>
                </c:pt>
                <c:pt idx="504">
                  <c:v>5.5349975940000113E-3</c:v>
                </c:pt>
                <c:pt idx="505">
                  <c:v>6.0800412240000134E-3</c:v>
                </c:pt>
                <c:pt idx="506">
                  <c:v>7.635265762600086E-3</c:v>
                </c:pt>
                <c:pt idx="507">
                  <c:v>9.8325915523001725E-3</c:v>
                </c:pt>
                <c:pt idx="508">
                  <c:v>1.0827546167000001E-2</c:v>
                </c:pt>
                <c:pt idx="509">
                  <c:v>1.0103141984999998E-2</c:v>
                </c:pt>
                <c:pt idx="510">
                  <c:v>9.2922465823000247E-3</c:v>
                </c:pt>
                <c:pt idx="511">
                  <c:v>8.9860293158001373E-3</c:v>
                </c:pt>
                <c:pt idx="512">
                  <c:v>9.2797757550000023E-3</c:v>
                </c:pt>
                <c:pt idx="513">
                  <c:v>1.0104086415000001E-2</c:v>
                </c:pt>
                <c:pt idx="514">
                  <c:v>1.1695153142000132E-2</c:v>
                </c:pt>
                <c:pt idx="515">
                  <c:v>1.3585034547000148E-2</c:v>
                </c:pt>
                <c:pt idx="516">
                  <c:v>1.3982455238000319E-2</c:v>
                </c:pt>
                <c:pt idx="517">
                  <c:v>1.3810536316000174E-2</c:v>
                </c:pt>
                <c:pt idx="518">
                  <c:v>1.3773088822E-2</c:v>
                </c:pt>
                <c:pt idx="519">
                  <c:v>1.3673235548000021E-2</c:v>
                </c:pt>
                <c:pt idx="520">
                  <c:v>1.3938042911999852E-2</c:v>
                </c:pt>
              </c:numCache>
            </c:numRef>
          </c:yVal>
          <c:smooth val="0"/>
        </c:ser>
        <c:ser>
          <c:idx val="0"/>
          <c:order val="1"/>
          <c:tx>
            <c:strRef>
              <c:f>Data!$O$1</c:f>
              <c:strCache>
                <c:ptCount val="1"/>
                <c:pt idx="0">
                  <c:v>UVA-I (WG360)</c:v>
                </c:pt>
              </c:strCache>
            </c:strRef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Data!$A$84:$A$604</c:f>
              <c:numCache>
                <c:formatCode>General</c:formatCode>
                <c:ptCount val="521"/>
                <c:pt idx="0">
                  <c:v>280</c:v>
                </c:pt>
                <c:pt idx="1">
                  <c:v>281</c:v>
                </c:pt>
                <c:pt idx="2">
                  <c:v>282</c:v>
                </c:pt>
                <c:pt idx="3">
                  <c:v>283</c:v>
                </c:pt>
                <c:pt idx="4">
                  <c:v>284</c:v>
                </c:pt>
                <c:pt idx="5">
                  <c:v>285</c:v>
                </c:pt>
                <c:pt idx="6">
                  <c:v>286</c:v>
                </c:pt>
                <c:pt idx="7">
                  <c:v>287</c:v>
                </c:pt>
                <c:pt idx="8">
                  <c:v>288</c:v>
                </c:pt>
                <c:pt idx="9">
                  <c:v>289</c:v>
                </c:pt>
                <c:pt idx="10">
                  <c:v>290</c:v>
                </c:pt>
                <c:pt idx="11">
                  <c:v>291</c:v>
                </c:pt>
                <c:pt idx="12">
                  <c:v>292</c:v>
                </c:pt>
                <c:pt idx="13">
                  <c:v>293</c:v>
                </c:pt>
                <c:pt idx="14">
                  <c:v>294</c:v>
                </c:pt>
                <c:pt idx="15">
                  <c:v>295</c:v>
                </c:pt>
                <c:pt idx="16">
                  <c:v>296</c:v>
                </c:pt>
                <c:pt idx="17">
                  <c:v>297</c:v>
                </c:pt>
                <c:pt idx="18">
                  <c:v>298</c:v>
                </c:pt>
                <c:pt idx="19">
                  <c:v>299</c:v>
                </c:pt>
                <c:pt idx="20">
                  <c:v>300</c:v>
                </c:pt>
                <c:pt idx="21">
                  <c:v>301</c:v>
                </c:pt>
                <c:pt idx="22">
                  <c:v>302</c:v>
                </c:pt>
                <c:pt idx="23">
                  <c:v>303</c:v>
                </c:pt>
                <c:pt idx="24">
                  <c:v>304</c:v>
                </c:pt>
                <c:pt idx="25">
                  <c:v>305</c:v>
                </c:pt>
                <c:pt idx="26">
                  <c:v>306</c:v>
                </c:pt>
                <c:pt idx="27">
                  <c:v>307</c:v>
                </c:pt>
                <c:pt idx="28">
                  <c:v>308</c:v>
                </c:pt>
                <c:pt idx="29">
                  <c:v>309</c:v>
                </c:pt>
                <c:pt idx="30">
                  <c:v>310</c:v>
                </c:pt>
                <c:pt idx="31">
                  <c:v>311</c:v>
                </c:pt>
                <c:pt idx="32">
                  <c:v>312</c:v>
                </c:pt>
                <c:pt idx="33">
                  <c:v>313</c:v>
                </c:pt>
                <c:pt idx="34">
                  <c:v>314</c:v>
                </c:pt>
                <c:pt idx="35">
                  <c:v>315</c:v>
                </c:pt>
                <c:pt idx="36">
                  <c:v>316</c:v>
                </c:pt>
                <c:pt idx="37">
                  <c:v>317</c:v>
                </c:pt>
                <c:pt idx="38">
                  <c:v>318</c:v>
                </c:pt>
                <c:pt idx="39">
                  <c:v>319</c:v>
                </c:pt>
                <c:pt idx="40">
                  <c:v>320</c:v>
                </c:pt>
                <c:pt idx="41">
                  <c:v>321</c:v>
                </c:pt>
                <c:pt idx="42">
                  <c:v>322</c:v>
                </c:pt>
                <c:pt idx="43">
                  <c:v>323</c:v>
                </c:pt>
                <c:pt idx="44">
                  <c:v>324</c:v>
                </c:pt>
                <c:pt idx="45">
                  <c:v>325</c:v>
                </c:pt>
                <c:pt idx="46">
                  <c:v>326</c:v>
                </c:pt>
                <c:pt idx="47">
                  <c:v>327</c:v>
                </c:pt>
                <c:pt idx="48">
                  <c:v>328</c:v>
                </c:pt>
                <c:pt idx="49">
                  <c:v>329</c:v>
                </c:pt>
                <c:pt idx="50">
                  <c:v>330</c:v>
                </c:pt>
                <c:pt idx="51">
                  <c:v>331</c:v>
                </c:pt>
                <c:pt idx="52">
                  <c:v>332</c:v>
                </c:pt>
                <c:pt idx="53">
                  <c:v>333</c:v>
                </c:pt>
                <c:pt idx="54">
                  <c:v>334</c:v>
                </c:pt>
                <c:pt idx="55">
                  <c:v>335</c:v>
                </c:pt>
                <c:pt idx="56">
                  <c:v>336</c:v>
                </c:pt>
                <c:pt idx="57">
                  <c:v>337</c:v>
                </c:pt>
                <c:pt idx="58">
                  <c:v>338</c:v>
                </c:pt>
                <c:pt idx="59">
                  <c:v>339</c:v>
                </c:pt>
                <c:pt idx="60">
                  <c:v>340</c:v>
                </c:pt>
                <c:pt idx="61">
                  <c:v>341</c:v>
                </c:pt>
                <c:pt idx="62">
                  <c:v>342</c:v>
                </c:pt>
                <c:pt idx="63">
                  <c:v>343</c:v>
                </c:pt>
                <c:pt idx="64">
                  <c:v>344</c:v>
                </c:pt>
                <c:pt idx="65">
                  <c:v>345</c:v>
                </c:pt>
                <c:pt idx="66">
                  <c:v>346</c:v>
                </c:pt>
                <c:pt idx="67">
                  <c:v>347</c:v>
                </c:pt>
                <c:pt idx="68">
                  <c:v>348</c:v>
                </c:pt>
                <c:pt idx="69">
                  <c:v>349</c:v>
                </c:pt>
                <c:pt idx="70">
                  <c:v>350</c:v>
                </c:pt>
                <c:pt idx="71">
                  <c:v>351</c:v>
                </c:pt>
                <c:pt idx="72">
                  <c:v>352</c:v>
                </c:pt>
                <c:pt idx="73">
                  <c:v>353</c:v>
                </c:pt>
                <c:pt idx="74">
                  <c:v>354</c:v>
                </c:pt>
                <c:pt idx="75">
                  <c:v>355</c:v>
                </c:pt>
                <c:pt idx="76">
                  <c:v>356</c:v>
                </c:pt>
                <c:pt idx="77">
                  <c:v>357</c:v>
                </c:pt>
                <c:pt idx="78">
                  <c:v>358</c:v>
                </c:pt>
                <c:pt idx="79">
                  <c:v>359</c:v>
                </c:pt>
                <c:pt idx="80">
                  <c:v>360</c:v>
                </c:pt>
                <c:pt idx="81">
                  <c:v>361</c:v>
                </c:pt>
                <c:pt idx="82">
                  <c:v>362</c:v>
                </c:pt>
                <c:pt idx="83">
                  <c:v>363</c:v>
                </c:pt>
                <c:pt idx="84">
                  <c:v>364</c:v>
                </c:pt>
                <c:pt idx="85">
                  <c:v>365</c:v>
                </c:pt>
                <c:pt idx="86">
                  <c:v>366</c:v>
                </c:pt>
                <c:pt idx="87">
                  <c:v>367</c:v>
                </c:pt>
                <c:pt idx="88">
                  <c:v>368</c:v>
                </c:pt>
                <c:pt idx="89">
                  <c:v>369</c:v>
                </c:pt>
                <c:pt idx="90">
                  <c:v>370</c:v>
                </c:pt>
                <c:pt idx="91">
                  <c:v>371</c:v>
                </c:pt>
                <c:pt idx="92">
                  <c:v>372</c:v>
                </c:pt>
                <c:pt idx="93">
                  <c:v>373</c:v>
                </c:pt>
                <c:pt idx="94">
                  <c:v>374</c:v>
                </c:pt>
                <c:pt idx="95">
                  <c:v>375</c:v>
                </c:pt>
                <c:pt idx="96">
                  <c:v>376</c:v>
                </c:pt>
                <c:pt idx="97">
                  <c:v>377</c:v>
                </c:pt>
                <c:pt idx="98">
                  <c:v>378</c:v>
                </c:pt>
                <c:pt idx="99">
                  <c:v>379</c:v>
                </c:pt>
                <c:pt idx="100">
                  <c:v>380</c:v>
                </c:pt>
                <c:pt idx="101">
                  <c:v>381</c:v>
                </c:pt>
                <c:pt idx="102">
                  <c:v>382</c:v>
                </c:pt>
                <c:pt idx="103">
                  <c:v>383</c:v>
                </c:pt>
                <c:pt idx="104">
                  <c:v>384</c:v>
                </c:pt>
                <c:pt idx="105">
                  <c:v>385</c:v>
                </c:pt>
                <c:pt idx="106">
                  <c:v>386</c:v>
                </c:pt>
                <c:pt idx="107">
                  <c:v>387</c:v>
                </c:pt>
                <c:pt idx="108">
                  <c:v>388</c:v>
                </c:pt>
                <c:pt idx="109">
                  <c:v>389</c:v>
                </c:pt>
                <c:pt idx="110">
                  <c:v>390</c:v>
                </c:pt>
                <c:pt idx="111">
                  <c:v>391</c:v>
                </c:pt>
                <c:pt idx="112">
                  <c:v>392</c:v>
                </c:pt>
                <c:pt idx="113">
                  <c:v>393</c:v>
                </c:pt>
                <c:pt idx="114">
                  <c:v>394</c:v>
                </c:pt>
                <c:pt idx="115">
                  <c:v>395</c:v>
                </c:pt>
                <c:pt idx="116">
                  <c:v>396</c:v>
                </c:pt>
                <c:pt idx="117">
                  <c:v>397</c:v>
                </c:pt>
                <c:pt idx="118">
                  <c:v>398</c:v>
                </c:pt>
                <c:pt idx="119">
                  <c:v>399</c:v>
                </c:pt>
                <c:pt idx="120">
                  <c:v>400</c:v>
                </c:pt>
                <c:pt idx="121">
                  <c:v>401</c:v>
                </c:pt>
                <c:pt idx="122">
                  <c:v>402</c:v>
                </c:pt>
                <c:pt idx="123">
                  <c:v>403</c:v>
                </c:pt>
                <c:pt idx="124">
                  <c:v>404</c:v>
                </c:pt>
                <c:pt idx="125">
                  <c:v>405</c:v>
                </c:pt>
                <c:pt idx="126">
                  <c:v>406</c:v>
                </c:pt>
                <c:pt idx="127">
                  <c:v>407</c:v>
                </c:pt>
                <c:pt idx="128">
                  <c:v>408</c:v>
                </c:pt>
                <c:pt idx="129">
                  <c:v>409</c:v>
                </c:pt>
                <c:pt idx="130">
                  <c:v>410</c:v>
                </c:pt>
                <c:pt idx="131">
                  <c:v>411</c:v>
                </c:pt>
                <c:pt idx="132">
                  <c:v>412</c:v>
                </c:pt>
                <c:pt idx="133">
                  <c:v>413</c:v>
                </c:pt>
                <c:pt idx="134">
                  <c:v>414</c:v>
                </c:pt>
                <c:pt idx="135">
                  <c:v>415</c:v>
                </c:pt>
                <c:pt idx="136">
                  <c:v>416</c:v>
                </c:pt>
                <c:pt idx="137">
                  <c:v>417</c:v>
                </c:pt>
                <c:pt idx="138">
                  <c:v>418</c:v>
                </c:pt>
                <c:pt idx="139">
                  <c:v>419</c:v>
                </c:pt>
                <c:pt idx="140">
                  <c:v>420</c:v>
                </c:pt>
                <c:pt idx="141">
                  <c:v>421</c:v>
                </c:pt>
                <c:pt idx="142">
                  <c:v>422</c:v>
                </c:pt>
                <c:pt idx="143">
                  <c:v>423</c:v>
                </c:pt>
                <c:pt idx="144">
                  <c:v>424</c:v>
                </c:pt>
                <c:pt idx="145">
                  <c:v>425</c:v>
                </c:pt>
                <c:pt idx="146">
                  <c:v>426</c:v>
                </c:pt>
                <c:pt idx="147">
                  <c:v>427</c:v>
                </c:pt>
                <c:pt idx="148">
                  <c:v>428</c:v>
                </c:pt>
                <c:pt idx="149">
                  <c:v>429</c:v>
                </c:pt>
                <c:pt idx="150">
                  <c:v>430</c:v>
                </c:pt>
                <c:pt idx="151">
                  <c:v>431</c:v>
                </c:pt>
                <c:pt idx="152">
                  <c:v>432</c:v>
                </c:pt>
                <c:pt idx="153">
                  <c:v>433</c:v>
                </c:pt>
                <c:pt idx="154">
                  <c:v>434</c:v>
                </c:pt>
                <c:pt idx="155">
                  <c:v>435</c:v>
                </c:pt>
                <c:pt idx="156">
                  <c:v>436</c:v>
                </c:pt>
                <c:pt idx="157">
                  <c:v>437</c:v>
                </c:pt>
                <c:pt idx="158">
                  <c:v>438</c:v>
                </c:pt>
                <c:pt idx="159">
                  <c:v>439</c:v>
                </c:pt>
                <c:pt idx="160">
                  <c:v>440</c:v>
                </c:pt>
                <c:pt idx="161">
                  <c:v>441</c:v>
                </c:pt>
                <c:pt idx="162">
                  <c:v>442</c:v>
                </c:pt>
                <c:pt idx="163">
                  <c:v>443</c:v>
                </c:pt>
                <c:pt idx="164">
                  <c:v>444</c:v>
                </c:pt>
                <c:pt idx="165">
                  <c:v>445</c:v>
                </c:pt>
                <c:pt idx="166">
                  <c:v>446</c:v>
                </c:pt>
                <c:pt idx="167">
                  <c:v>447</c:v>
                </c:pt>
                <c:pt idx="168">
                  <c:v>448</c:v>
                </c:pt>
                <c:pt idx="169">
                  <c:v>449</c:v>
                </c:pt>
                <c:pt idx="170">
                  <c:v>450</c:v>
                </c:pt>
                <c:pt idx="171">
                  <c:v>451</c:v>
                </c:pt>
                <c:pt idx="172">
                  <c:v>452</c:v>
                </c:pt>
                <c:pt idx="173">
                  <c:v>453</c:v>
                </c:pt>
                <c:pt idx="174">
                  <c:v>454</c:v>
                </c:pt>
                <c:pt idx="175">
                  <c:v>455</c:v>
                </c:pt>
                <c:pt idx="176">
                  <c:v>456</c:v>
                </c:pt>
                <c:pt idx="177">
                  <c:v>457</c:v>
                </c:pt>
                <c:pt idx="178">
                  <c:v>458</c:v>
                </c:pt>
                <c:pt idx="179">
                  <c:v>459</c:v>
                </c:pt>
                <c:pt idx="180">
                  <c:v>460</c:v>
                </c:pt>
                <c:pt idx="181">
                  <c:v>461</c:v>
                </c:pt>
                <c:pt idx="182">
                  <c:v>462</c:v>
                </c:pt>
                <c:pt idx="183">
                  <c:v>463</c:v>
                </c:pt>
                <c:pt idx="184">
                  <c:v>464</c:v>
                </c:pt>
                <c:pt idx="185">
                  <c:v>465</c:v>
                </c:pt>
                <c:pt idx="186">
                  <c:v>466</c:v>
                </c:pt>
                <c:pt idx="187">
                  <c:v>467</c:v>
                </c:pt>
                <c:pt idx="188">
                  <c:v>468</c:v>
                </c:pt>
                <c:pt idx="189">
                  <c:v>469</c:v>
                </c:pt>
                <c:pt idx="190">
                  <c:v>470</c:v>
                </c:pt>
                <c:pt idx="191">
                  <c:v>471</c:v>
                </c:pt>
                <c:pt idx="192">
                  <c:v>472</c:v>
                </c:pt>
                <c:pt idx="193">
                  <c:v>473</c:v>
                </c:pt>
                <c:pt idx="194">
                  <c:v>474</c:v>
                </c:pt>
                <c:pt idx="195">
                  <c:v>475</c:v>
                </c:pt>
                <c:pt idx="196">
                  <c:v>476</c:v>
                </c:pt>
                <c:pt idx="197">
                  <c:v>477</c:v>
                </c:pt>
                <c:pt idx="198">
                  <c:v>478</c:v>
                </c:pt>
                <c:pt idx="199">
                  <c:v>479</c:v>
                </c:pt>
                <c:pt idx="200">
                  <c:v>480</c:v>
                </c:pt>
                <c:pt idx="201">
                  <c:v>481</c:v>
                </c:pt>
                <c:pt idx="202">
                  <c:v>482</c:v>
                </c:pt>
                <c:pt idx="203">
                  <c:v>483</c:v>
                </c:pt>
                <c:pt idx="204">
                  <c:v>484</c:v>
                </c:pt>
                <c:pt idx="205">
                  <c:v>485</c:v>
                </c:pt>
                <c:pt idx="206">
                  <c:v>486</c:v>
                </c:pt>
                <c:pt idx="207">
                  <c:v>487</c:v>
                </c:pt>
                <c:pt idx="208">
                  <c:v>488</c:v>
                </c:pt>
                <c:pt idx="209">
                  <c:v>489</c:v>
                </c:pt>
                <c:pt idx="210">
                  <c:v>490</c:v>
                </c:pt>
                <c:pt idx="211">
                  <c:v>491</c:v>
                </c:pt>
                <c:pt idx="212">
                  <c:v>492</c:v>
                </c:pt>
                <c:pt idx="213">
                  <c:v>493</c:v>
                </c:pt>
                <c:pt idx="214">
                  <c:v>494</c:v>
                </c:pt>
                <c:pt idx="215">
                  <c:v>495</c:v>
                </c:pt>
                <c:pt idx="216">
                  <c:v>496</c:v>
                </c:pt>
                <c:pt idx="217">
                  <c:v>497</c:v>
                </c:pt>
                <c:pt idx="218">
                  <c:v>498</c:v>
                </c:pt>
                <c:pt idx="219">
                  <c:v>499</c:v>
                </c:pt>
                <c:pt idx="220">
                  <c:v>500</c:v>
                </c:pt>
                <c:pt idx="221">
                  <c:v>501</c:v>
                </c:pt>
                <c:pt idx="222">
                  <c:v>502</c:v>
                </c:pt>
                <c:pt idx="223">
                  <c:v>503</c:v>
                </c:pt>
                <c:pt idx="224">
                  <c:v>504</c:v>
                </c:pt>
                <c:pt idx="225">
                  <c:v>505</c:v>
                </c:pt>
                <c:pt idx="226">
                  <c:v>506</c:v>
                </c:pt>
                <c:pt idx="227">
                  <c:v>507</c:v>
                </c:pt>
                <c:pt idx="228">
                  <c:v>508</c:v>
                </c:pt>
                <c:pt idx="229">
                  <c:v>509</c:v>
                </c:pt>
                <c:pt idx="230">
                  <c:v>510</c:v>
                </c:pt>
                <c:pt idx="231">
                  <c:v>511</c:v>
                </c:pt>
                <c:pt idx="232">
                  <c:v>512</c:v>
                </c:pt>
                <c:pt idx="233">
                  <c:v>513</c:v>
                </c:pt>
                <c:pt idx="234">
                  <c:v>514</c:v>
                </c:pt>
                <c:pt idx="235">
                  <c:v>515</c:v>
                </c:pt>
                <c:pt idx="236">
                  <c:v>516</c:v>
                </c:pt>
                <c:pt idx="237">
                  <c:v>517</c:v>
                </c:pt>
                <c:pt idx="238">
                  <c:v>518</c:v>
                </c:pt>
                <c:pt idx="239">
                  <c:v>519</c:v>
                </c:pt>
                <c:pt idx="240">
                  <c:v>520</c:v>
                </c:pt>
                <c:pt idx="241">
                  <c:v>521</c:v>
                </c:pt>
                <c:pt idx="242">
                  <c:v>522</c:v>
                </c:pt>
                <c:pt idx="243">
                  <c:v>523</c:v>
                </c:pt>
                <c:pt idx="244">
                  <c:v>524</c:v>
                </c:pt>
                <c:pt idx="245">
                  <c:v>525</c:v>
                </c:pt>
                <c:pt idx="246">
                  <c:v>526</c:v>
                </c:pt>
                <c:pt idx="247">
                  <c:v>527</c:v>
                </c:pt>
                <c:pt idx="248">
                  <c:v>528</c:v>
                </c:pt>
                <c:pt idx="249">
                  <c:v>529</c:v>
                </c:pt>
                <c:pt idx="250">
                  <c:v>530</c:v>
                </c:pt>
                <c:pt idx="251">
                  <c:v>531</c:v>
                </c:pt>
                <c:pt idx="252">
                  <c:v>532</c:v>
                </c:pt>
                <c:pt idx="253">
                  <c:v>533</c:v>
                </c:pt>
                <c:pt idx="254">
                  <c:v>534</c:v>
                </c:pt>
                <c:pt idx="255">
                  <c:v>535</c:v>
                </c:pt>
                <c:pt idx="256">
                  <c:v>536</c:v>
                </c:pt>
                <c:pt idx="257">
                  <c:v>537</c:v>
                </c:pt>
                <c:pt idx="258">
                  <c:v>538</c:v>
                </c:pt>
                <c:pt idx="259">
                  <c:v>539</c:v>
                </c:pt>
                <c:pt idx="260">
                  <c:v>540</c:v>
                </c:pt>
                <c:pt idx="261">
                  <c:v>541</c:v>
                </c:pt>
                <c:pt idx="262">
                  <c:v>542</c:v>
                </c:pt>
                <c:pt idx="263">
                  <c:v>543</c:v>
                </c:pt>
                <c:pt idx="264">
                  <c:v>544</c:v>
                </c:pt>
                <c:pt idx="265">
                  <c:v>545</c:v>
                </c:pt>
                <c:pt idx="266">
                  <c:v>546</c:v>
                </c:pt>
                <c:pt idx="267">
                  <c:v>547</c:v>
                </c:pt>
                <c:pt idx="268">
                  <c:v>548</c:v>
                </c:pt>
                <c:pt idx="269">
                  <c:v>549</c:v>
                </c:pt>
                <c:pt idx="270">
                  <c:v>550</c:v>
                </c:pt>
                <c:pt idx="271">
                  <c:v>551</c:v>
                </c:pt>
                <c:pt idx="272">
                  <c:v>552</c:v>
                </c:pt>
                <c:pt idx="273">
                  <c:v>553</c:v>
                </c:pt>
                <c:pt idx="274">
                  <c:v>554</c:v>
                </c:pt>
                <c:pt idx="275">
                  <c:v>555</c:v>
                </c:pt>
                <c:pt idx="276">
                  <c:v>556</c:v>
                </c:pt>
                <c:pt idx="277">
                  <c:v>557</c:v>
                </c:pt>
                <c:pt idx="278">
                  <c:v>558</c:v>
                </c:pt>
                <c:pt idx="279">
                  <c:v>559</c:v>
                </c:pt>
                <c:pt idx="280">
                  <c:v>560</c:v>
                </c:pt>
                <c:pt idx="281">
                  <c:v>561</c:v>
                </c:pt>
                <c:pt idx="282">
                  <c:v>562</c:v>
                </c:pt>
                <c:pt idx="283">
                  <c:v>563</c:v>
                </c:pt>
                <c:pt idx="284">
                  <c:v>564</c:v>
                </c:pt>
                <c:pt idx="285">
                  <c:v>565</c:v>
                </c:pt>
                <c:pt idx="286">
                  <c:v>566</c:v>
                </c:pt>
                <c:pt idx="287">
                  <c:v>567</c:v>
                </c:pt>
                <c:pt idx="288">
                  <c:v>568</c:v>
                </c:pt>
                <c:pt idx="289">
                  <c:v>569</c:v>
                </c:pt>
                <c:pt idx="290">
                  <c:v>570</c:v>
                </c:pt>
                <c:pt idx="291">
                  <c:v>571</c:v>
                </c:pt>
                <c:pt idx="292">
                  <c:v>572</c:v>
                </c:pt>
                <c:pt idx="293">
                  <c:v>573</c:v>
                </c:pt>
                <c:pt idx="294">
                  <c:v>574</c:v>
                </c:pt>
                <c:pt idx="295">
                  <c:v>575</c:v>
                </c:pt>
                <c:pt idx="296">
                  <c:v>576</c:v>
                </c:pt>
                <c:pt idx="297">
                  <c:v>577</c:v>
                </c:pt>
                <c:pt idx="298">
                  <c:v>578</c:v>
                </c:pt>
                <c:pt idx="299">
                  <c:v>579</c:v>
                </c:pt>
                <c:pt idx="300">
                  <c:v>580</c:v>
                </c:pt>
                <c:pt idx="301">
                  <c:v>581</c:v>
                </c:pt>
                <c:pt idx="302">
                  <c:v>582</c:v>
                </c:pt>
                <c:pt idx="303">
                  <c:v>583</c:v>
                </c:pt>
                <c:pt idx="304">
                  <c:v>584</c:v>
                </c:pt>
                <c:pt idx="305">
                  <c:v>585</c:v>
                </c:pt>
                <c:pt idx="306">
                  <c:v>586</c:v>
                </c:pt>
                <c:pt idx="307">
                  <c:v>587</c:v>
                </c:pt>
                <c:pt idx="308">
                  <c:v>588</c:v>
                </c:pt>
                <c:pt idx="309">
                  <c:v>589</c:v>
                </c:pt>
                <c:pt idx="310">
                  <c:v>590</c:v>
                </c:pt>
                <c:pt idx="311">
                  <c:v>591</c:v>
                </c:pt>
                <c:pt idx="312">
                  <c:v>592</c:v>
                </c:pt>
                <c:pt idx="313">
                  <c:v>593</c:v>
                </c:pt>
                <c:pt idx="314">
                  <c:v>594</c:v>
                </c:pt>
                <c:pt idx="315">
                  <c:v>595</c:v>
                </c:pt>
                <c:pt idx="316">
                  <c:v>596</c:v>
                </c:pt>
                <c:pt idx="317">
                  <c:v>597</c:v>
                </c:pt>
                <c:pt idx="318">
                  <c:v>598</c:v>
                </c:pt>
                <c:pt idx="319">
                  <c:v>599</c:v>
                </c:pt>
                <c:pt idx="320">
                  <c:v>600</c:v>
                </c:pt>
                <c:pt idx="321">
                  <c:v>601</c:v>
                </c:pt>
                <c:pt idx="322">
                  <c:v>602</c:v>
                </c:pt>
                <c:pt idx="323">
                  <c:v>603</c:v>
                </c:pt>
                <c:pt idx="324">
                  <c:v>604</c:v>
                </c:pt>
                <c:pt idx="325">
                  <c:v>605</c:v>
                </c:pt>
                <c:pt idx="326">
                  <c:v>606</c:v>
                </c:pt>
                <c:pt idx="327">
                  <c:v>607</c:v>
                </c:pt>
                <c:pt idx="328">
                  <c:v>608</c:v>
                </c:pt>
                <c:pt idx="329">
                  <c:v>609</c:v>
                </c:pt>
                <c:pt idx="330">
                  <c:v>610</c:v>
                </c:pt>
                <c:pt idx="331">
                  <c:v>611</c:v>
                </c:pt>
                <c:pt idx="332">
                  <c:v>612</c:v>
                </c:pt>
                <c:pt idx="333">
                  <c:v>613</c:v>
                </c:pt>
                <c:pt idx="334">
                  <c:v>614</c:v>
                </c:pt>
                <c:pt idx="335">
                  <c:v>615</c:v>
                </c:pt>
                <c:pt idx="336">
                  <c:v>616</c:v>
                </c:pt>
                <c:pt idx="337">
                  <c:v>617</c:v>
                </c:pt>
                <c:pt idx="338">
                  <c:v>618</c:v>
                </c:pt>
                <c:pt idx="339">
                  <c:v>619</c:v>
                </c:pt>
                <c:pt idx="340">
                  <c:v>620</c:v>
                </c:pt>
                <c:pt idx="341">
                  <c:v>621</c:v>
                </c:pt>
                <c:pt idx="342">
                  <c:v>622</c:v>
                </c:pt>
                <c:pt idx="343">
                  <c:v>623</c:v>
                </c:pt>
                <c:pt idx="344">
                  <c:v>624</c:v>
                </c:pt>
                <c:pt idx="345">
                  <c:v>625</c:v>
                </c:pt>
                <c:pt idx="346">
                  <c:v>626</c:v>
                </c:pt>
                <c:pt idx="347">
                  <c:v>627</c:v>
                </c:pt>
                <c:pt idx="348">
                  <c:v>628</c:v>
                </c:pt>
                <c:pt idx="349">
                  <c:v>629</c:v>
                </c:pt>
                <c:pt idx="350">
                  <c:v>630</c:v>
                </c:pt>
                <c:pt idx="351">
                  <c:v>631</c:v>
                </c:pt>
                <c:pt idx="352">
                  <c:v>632</c:v>
                </c:pt>
                <c:pt idx="353">
                  <c:v>633</c:v>
                </c:pt>
                <c:pt idx="354">
                  <c:v>634</c:v>
                </c:pt>
                <c:pt idx="355">
                  <c:v>635</c:v>
                </c:pt>
                <c:pt idx="356">
                  <c:v>636</c:v>
                </c:pt>
                <c:pt idx="357">
                  <c:v>637</c:v>
                </c:pt>
                <c:pt idx="358">
                  <c:v>638</c:v>
                </c:pt>
                <c:pt idx="359">
                  <c:v>639</c:v>
                </c:pt>
                <c:pt idx="360">
                  <c:v>640</c:v>
                </c:pt>
                <c:pt idx="361">
                  <c:v>641</c:v>
                </c:pt>
                <c:pt idx="362">
                  <c:v>642</c:v>
                </c:pt>
                <c:pt idx="363">
                  <c:v>643</c:v>
                </c:pt>
                <c:pt idx="364">
                  <c:v>644</c:v>
                </c:pt>
                <c:pt idx="365">
                  <c:v>645</c:v>
                </c:pt>
                <c:pt idx="366">
                  <c:v>646</c:v>
                </c:pt>
                <c:pt idx="367">
                  <c:v>647</c:v>
                </c:pt>
                <c:pt idx="368">
                  <c:v>648</c:v>
                </c:pt>
                <c:pt idx="369">
                  <c:v>649</c:v>
                </c:pt>
                <c:pt idx="370">
                  <c:v>650</c:v>
                </c:pt>
                <c:pt idx="371">
                  <c:v>651</c:v>
                </c:pt>
                <c:pt idx="372">
                  <c:v>652</c:v>
                </c:pt>
                <c:pt idx="373">
                  <c:v>653</c:v>
                </c:pt>
                <c:pt idx="374">
                  <c:v>654</c:v>
                </c:pt>
                <c:pt idx="375">
                  <c:v>655</c:v>
                </c:pt>
                <c:pt idx="376">
                  <c:v>656</c:v>
                </c:pt>
                <c:pt idx="377">
                  <c:v>657</c:v>
                </c:pt>
                <c:pt idx="378">
                  <c:v>658</c:v>
                </c:pt>
                <c:pt idx="379">
                  <c:v>659</c:v>
                </c:pt>
                <c:pt idx="380">
                  <c:v>660</c:v>
                </c:pt>
                <c:pt idx="381">
                  <c:v>661</c:v>
                </c:pt>
                <c:pt idx="382">
                  <c:v>662</c:v>
                </c:pt>
                <c:pt idx="383">
                  <c:v>663</c:v>
                </c:pt>
                <c:pt idx="384">
                  <c:v>664</c:v>
                </c:pt>
                <c:pt idx="385">
                  <c:v>665</c:v>
                </c:pt>
                <c:pt idx="386">
                  <c:v>666</c:v>
                </c:pt>
                <c:pt idx="387">
                  <c:v>667</c:v>
                </c:pt>
                <c:pt idx="388">
                  <c:v>668</c:v>
                </c:pt>
                <c:pt idx="389">
                  <c:v>669</c:v>
                </c:pt>
                <c:pt idx="390">
                  <c:v>670</c:v>
                </c:pt>
                <c:pt idx="391">
                  <c:v>671</c:v>
                </c:pt>
                <c:pt idx="392">
                  <c:v>672</c:v>
                </c:pt>
                <c:pt idx="393">
                  <c:v>673</c:v>
                </c:pt>
                <c:pt idx="394">
                  <c:v>674</c:v>
                </c:pt>
                <c:pt idx="395">
                  <c:v>675</c:v>
                </c:pt>
                <c:pt idx="396">
                  <c:v>676</c:v>
                </c:pt>
                <c:pt idx="397">
                  <c:v>677</c:v>
                </c:pt>
                <c:pt idx="398">
                  <c:v>678</c:v>
                </c:pt>
                <c:pt idx="399">
                  <c:v>679</c:v>
                </c:pt>
                <c:pt idx="400">
                  <c:v>680</c:v>
                </c:pt>
                <c:pt idx="401">
                  <c:v>681</c:v>
                </c:pt>
                <c:pt idx="402">
                  <c:v>682</c:v>
                </c:pt>
                <c:pt idx="403">
                  <c:v>683</c:v>
                </c:pt>
                <c:pt idx="404">
                  <c:v>684</c:v>
                </c:pt>
                <c:pt idx="405">
                  <c:v>685</c:v>
                </c:pt>
                <c:pt idx="406">
                  <c:v>686</c:v>
                </c:pt>
                <c:pt idx="407">
                  <c:v>687</c:v>
                </c:pt>
                <c:pt idx="408">
                  <c:v>688</c:v>
                </c:pt>
                <c:pt idx="409">
                  <c:v>689</c:v>
                </c:pt>
                <c:pt idx="410">
                  <c:v>690</c:v>
                </c:pt>
                <c:pt idx="411">
                  <c:v>691</c:v>
                </c:pt>
                <c:pt idx="412">
                  <c:v>692</c:v>
                </c:pt>
                <c:pt idx="413">
                  <c:v>693</c:v>
                </c:pt>
                <c:pt idx="414">
                  <c:v>694</c:v>
                </c:pt>
                <c:pt idx="415">
                  <c:v>695</c:v>
                </c:pt>
                <c:pt idx="416">
                  <c:v>696</c:v>
                </c:pt>
                <c:pt idx="417">
                  <c:v>697</c:v>
                </c:pt>
                <c:pt idx="418">
                  <c:v>698</c:v>
                </c:pt>
                <c:pt idx="419">
                  <c:v>699</c:v>
                </c:pt>
                <c:pt idx="420">
                  <c:v>700</c:v>
                </c:pt>
                <c:pt idx="421">
                  <c:v>701</c:v>
                </c:pt>
                <c:pt idx="422">
                  <c:v>702</c:v>
                </c:pt>
                <c:pt idx="423">
                  <c:v>703</c:v>
                </c:pt>
                <c:pt idx="424">
                  <c:v>704</c:v>
                </c:pt>
                <c:pt idx="425">
                  <c:v>705</c:v>
                </c:pt>
                <c:pt idx="426">
                  <c:v>706</c:v>
                </c:pt>
                <c:pt idx="427">
                  <c:v>707</c:v>
                </c:pt>
                <c:pt idx="428">
                  <c:v>708</c:v>
                </c:pt>
                <c:pt idx="429">
                  <c:v>709</c:v>
                </c:pt>
                <c:pt idx="430">
                  <c:v>710</c:v>
                </c:pt>
                <c:pt idx="431">
                  <c:v>711</c:v>
                </c:pt>
                <c:pt idx="432">
                  <c:v>712</c:v>
                </c:pt>
                <c:pt idx="433">
                  <c:v>713</c:v>
                </c:pt>
                <c:pt idx="434">
                  <c:v>714</c:v>
                </c:pt>
                <c:pt idx="435">
                  <c:v>715</c:v>
                </c:pt>
                <c:pt idx="436">
                  <c:v>716</c:v>
                </c:pt>
                <c:pt idx="437">
                  <c:v>717</c:v>
                </c:pt>
                <c:pt idx="438">
                  <c:v>718</c:v>
                </c:pt>
                <c:pt idx="439">
                  <c:v>719</c:v>
                </c:pt>
                <c:pt idx="440">
                  <c:v>720</c:v>
                </c:pt>
                <c:pt idx="441">
                  <c:v>721</c:v>
                </c:pt>
                <c:pt idx="442">
                  <c:v>722</c:v>
                </c:pt>
                <c:pt idx="443">
                  <c:v>723</c:v>
                </c:pt>
                <c:pt idx="444">
                  <c:v>724</c:v>
                </c:pt>
                <c:pt idx="445">
                  <c:v>725</c:v>
                </c:pt>
                <c:pt idx="446">
                  <c:v>726</c:v>
                </c:pt>
                <c:pt idx="447">
                  <c:v>727</c:v>
                </c:pt>
                <c:pt idx="448">
                  <c:v>728</c:v>
                </c:pt>
                <c:pt idx="449">
                  <c:v>729</c:v>
                </c:pt>
                <c:pt idx="450">
                  <c:v>730</c:v>
                </c:pt>
                <c:pt idx="451">
                  <c:v>731</c:v>
                </c:pt>
                <c:pt idx="452">
                  <c:v>732</c:v>
                </c:pt>
                <c:pt idx="453">
                  <c:v>733</c:v>
                </c:pt>
                <c:pt idx="454">
                  <c:v>734</c:v>
                </c:pt>
                <c:pt idx="455">
                  <c:v>735</c:v>
                </c:pt>
                <c:pt idx="456">
                  <c:v>736</c:v>
                </c:pt>
                <c:pt idx="457">
                  <c:v>737</c:v>
                </c:pt>
                <c:pt idx="458">
                  <c:v>738</c:v>
                </c:pt>
                <c:pt idx="459">
                  <c:v>739</c:v>
                </c:pt>
                <c:pt idx="460">
                  <c:v>740</c:v>
                </c:pt>
                <c:pt idx="461">
                  <c:v>741</c:v>
                </c:pt>
                <c:pt idx="462">
                  <c:v>742</c:v>
                </c:pt>
                <c:pt idx="463">
                  <c:v>743</c:v>
                </c:pt>
                <c:pt idx="464">
                  <c:v>744</c:v>
                </c:pt>
                <c:pt idx="465">
                  <c:v>745</c:v>
                </c:pt>
                <c:pt idx="466">
                  <c:v>746</c:v>
                </c:pt>
                <c:pt idx="467">
                  <c:v>747</c:v>
                </c:pt>
                <c:pt idx="468">
                  <c:v>748</c:v>
                </c:pt>
                <c:pt idx="469">
                  <c:v>749</c:v>
                </c:pt>
                <c:pt idx="470">
                  <c:v>750</c:v>
                </c:pt>
                <c:pt idx="471">
                  <c:v>751</c:v>
                </c:pt>
                <c:pt idx="472">
                  <c:v>752</c:v>
                </c:pt>
                <c:pt idx="473">
                  <c:v>753</c:v>
                </c:pt>
                <c:pt idx="474">
                  <c:v>754</c:v>
                </c:pt>
                <c:pt idx="475">
                  <c:v>755</c:v>
                </c:pt>
                <c:pt idx="476">
                  <c:v>756</c:v>
                </c:pt>
                <c:pt idx="477">
                  <c:v>757</c:v>
                </c:pt>
                <c:pt idx="478">
                  <c:v>758</c:v>
                </c:pt>
                <c:pt idx="479">
                  <c:v>759</c:v>
                </c:pt>
                <c:pt idx="480">
                  <c:v>760</c:v>
                </c:pt>
                <c:pt idx="481">
                  <c:v>761</c:v>
                </c:pt>
                <c:pt idx="482">
                  <c:v>762</c:v>
                </c:pt>
                <c:pt idx="483">
                  <c:v>763</c:v>
                </c:pt>
                <c:pt idx="484">
                  <c:v>764</c:v>
                </c:pt>
                <c:pt idx="485">
                  <c:v>765</c:v>
                </c:pt>
                <c:pt idx="486">
                  <c:v>766</c:v>
                </c:pt>
                <c:pt idx="487">
                  <c:v>767</c:v>
                </c:pt>
                <c:pt idx="488">
                  <c:v>768</c:v>
                </c:pt>
                <c:pt idx="489">
                  <c:v>769</c:v>
                </c:pt>
                <c:pt idx="490">
                  <c:v>770</c:v>
                </c:pt>
                <c:pt idx="491">
                  <c:v>771</c:v>
                </c:pt>
                <c:pt idx="492">
                  <c:v>772</c:v>
                </c:pt>
                <c:pt idx="493">
                  <c:v>773</c:v>
                </c:pt>
                <c:pt idx="494">
                  <c:v>774</c:v>
                </c:pt>
                <c:pt idx="495">
                  <c:v>775</c:v>
                </c:pt>
                <c:pt idx="496">
                  <c:v>776</c:v>
                </c:pt>
                <c:pt idx="497">
                  <c:v>777</c:v>
                </c:pt>
                <c:pt idx="498">
                  <c:v>778</c:v>
                </c:pt>
                <c:pt idx="499">
                  <c:v>779</c:v>
                </c:pt>
                <c:pt idx="500">
                  <c:v>780</c:v>
                </c:pt>
                <c:pt idx="501">
                  <c:v>781</c:v>
                </c:pt>
                <c:pt idx="502">
                  <c:v>782</c:v>
                </c:pt>
                <c:pt idx="503">
                  <c:v>783</c:v>
                </c:pt>
                <c:pt idx="504">
                  <c:v>784</c:v>
                </c:pt>
                <c:pt idx="505">
                  <c:v>785</c:v>
                </c:pt>
                <c:pt idx="506">
                  <c:v>786</c:v>
                </c:pt>
                <c:pt idx="507">
                  <c:v>787</c:v>
                </c:pt>
                <c:pt idx="508">
                  <c:v>788</c:v>
                </c:pt>
                <c:pt idx="509">
                  <c:v>789</c:v>
                </c:pt>
                <c:pt idx="510">
                  <c:v>790</c:v>
                </c:pt>
                <c:pt idx="511">
                  <c:v>791</c:v>
                </c:pt>
                <c:pt idx="512">
                  <c:v>792</c:v>
                </c:pt>
                <c:pt idx="513">
                  <c:v>793</c:v>
                </c:pt>
                <c:pt idx="514">
                  <c:v>794</c:v>
                </c:pt>
                <c:pt idx="515">
                  <c:v>795</c:v>
                </c:pt>
                <c:pt idx="516">
                  <c:v>796</c:v>
                </c:pt>
                <c:pt idx="517">
                  <c:v>797</c:v>
                </c:pt>
                <c:pt idx="518">
                  <c:v>798</c:v>
                </c:pt>
                <c:pt idx="519">
                  <c:v>799</c:v>
                </c:pt>
                <c:pt idx="520">
                  <c:v>800</c:v>
                </c:pt>
              </c:numCache>
            </c:numRef>
          </c:xVal>
          <c:yVal>
            <c:numRef>
              <c:f>Data!$O$84:$O$604</c:f>
              <c:numCache>
                <c:formatCode>0.00E+00</c:formatCode>
                <c:ptCount val="52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1.0840389644000366E-5</c:v>
                </c:pt>
                <c:pt idx="50">
                  <c:v>4.7829138300000011E-5</c:v>
                </c:pt>
                <c:pt idx="51">
                  <c:v>9.4523200379001995E-5</c:v>
                </c:pt>
                <c:pt idx="52">
                  <c:v>1.5402156616000311E-4</c:v>
                </c:pt>
                <c:pt idx="53">
                  <c:v>1.9780177208000485E-4</c:v>
                </c:pt>
                <c:pt idx="54">
                  <c:v>2.7244147549000691E-4</c:v>
                </c:pt>
                <c:pt idx="55">
                  <c:v>3.4510360969000256E-4</c:v>
                </c:pt>
                <c:pt idx="56">
                  <c:v>4.6591993904000745E-4</c:v>
                </c:pt>
                <c:pt idx="57">
                  <c:v>6.1328574497000092E-4</c:v>
                </c:pt>
                <c:pt idx="58">
                  <c:v>8.6436715316000063E-4</c:v>
                </c:pt>
                <c:pt idx="59">
                  <c:v>1.2638105662000165E-3</c:v>
                </c:pt>
                <c:pt idx="60">
                  <c:v>1.8776919806000021E-3</c:v>
                </c:pt>
                <c:pt idx="61">
                  <c:v>2.7983535125000419E-3</c:v>
                </c:pt>
                <c:pt idx="62">
                  <c:v>4.1845064610000005E-3</c:v>
                </c:pt>
                <c:pt idx="63">
                  <c:v>6.1616242895000013E-3</c:v>
                </c:pt>
                <c:pt idx="64">
                  <c:v>8.8950491703001563E-3</c:v>
                </c:pt>
                <c:pt idx="65">
                  <c:v>1.3005159796000254E-2</c:v>
                </c:pt>
                <c:pt idx="66">
                  <c:v>1.8786739950000009E-2</c:v>
                </c:pt>
                <c:pt idx="67">
                  <c:v>2.6359118477000471E-2</c:v>
                </c:pt>
                <c:pt idx="68">
                  <c:v>3.5337017032000359E-2</c:v>
                </c:pt>
                <c:pt idx="69">
                  <c:v>4.6057508988999955E-2</c:v>
                </c:pt>
                <c:pt idx="70">
                  <c:v>5.6344771657000033E-2</c:v>
                </c:pt>
                <c:pt idx="71">
                  <c:v>6.7534952767E-2</c:v>
                </c:pt>
                <c:pt idx="72">
                  <c:v>7.7740624076000533E-2</c:v>
                </c:pt>
                <c:pt idx="73">
                  <c:v>9.0014728948000208E-2</c:v>
                </c:pt>
                <c:pt idx="74">
                  <c:v>0.10408038205</c:v>
                </c:pt>
                <c:pt idx="75">
                  <c:v>0.11828620064000089</c:v>
                </c:pt>
                <c:pt idx="76">
                  <c:v>0.13197296658999999</c:v>
                </c:pt>
                <c:pt idx="77">
                  <c:v>0.14503920286000244</c:v>
                </c:pt>
                <c:pt idx="78">
                  <c:v>0.15860591845999999</c:v>
                </c:pt>
                <c:pt idx="79">
                  <c:v>0.17010354512</c:v>
                </c:pt>
                <c:pt idx="80">
                  <c:v>0.18345007757000173</c:v>
                </c:pt>
                <c:pt idx="81">
                  <c:v>0.19635856283000003</c:v>
                </c:pt>
                <c:pt idx="82">
                  <c:v>0.20774498703000252</c:v>
                </c:pt>
                <c:pt idx="83">
                  <c:v>0.21983428486000312</c:v>
                </c:pt>
                <c:pt idx="84">
                  <c:v>0.22860176558</c:v>
                </c:pt>
                <c:pt idx="85">
                  <c:v>0.23779211114000198</c:v>
                </c:pt>
                <c:pt idx="86">
                  <c:v>0.24617615224999997</c:v>
                </c:pt>
                <c:pt idx="87">
                  <c:v>0.25480714653000003</c:v>
                </c:pt>
                <c:pt idx="88">
                  <c:v>0.26371473301999998</c:v>
                </c:pt>
                <c:pt idx="89">
                  <c:v>0.27077029293000032</c:v>
                </c:pt>
                <c:pt idx="90">
                  <c:v>0.27928711009999996</c:v>
                </c:pt>
                <c:pt idx="91">
                  <c:v>0.28318639202000317</c:v>
                </c:pt>
                <c:pt idx="92">
                  <c:v>0.28923810902999997</c:v>
                </c:pt>
                <c:pt idx="93">
                  <c:v>0.29668511490000032</c:v>
                </c:pt>
                <c:pt idx="94">
                  <c:v>0.29810815461000001</c:v>
                </c:pt>
                <c:pt idx="95">
                  <c:v>0.30320148027000032</c:v>
                </c:pt>
                <c:pt idx="96">
                  <c:v>0.30742873784000646</c:v>
                </c:pt>
                <c:pt idx="97">
                  <c:v>0.31244774180000318</c:v>
                </c:pt>
                <c:pt idx="98">
                  <c:v>0.31747210316000629</c:v>
                </c:pt>
                <c:pt idx="99">
                  <c:v>0.32200772108000425</c:v>
                </c:pt>
                <c:pt idx="100">
                  <c:v>0.32742416130000851</c:v>
                </c:pt>
                <c:pt idx="101">
                  <c:v>0.33315666325000798</c:v>
                </c:pt>
                <c:pt idx="102">
                  <c:v>0.3365799990500063</c:v>
                </c:pt>
                <c:pt idx="103">
                  <c:v>0.34033925585000008</c:v>
                </c:pt>
                <c:pt idx="104">
                  <c:v>0.34017354489000001</c:v>
                </c:pt>
                <c:pt idx="105">
                  <c:v>0.34409807763000289</c:v>
                </c:pt>
                <c:pt idx="106">
                  <c:v>0.34556056470000374</c:v>
                </c:pt>
                <c:pt idx="107">
                  <c:v>0.34769657646000007</c:v>
                </c:pt>
                <c:pt idx="108">
                  <c:v>0.35028698761000504</c:v>
                </c:pt>
                <c:pt idx="109">
                  <c:v>0.35264791703999998</c:v>
                </c:pt>
                <c:pt idx="110">
                  <c:v>0.35576090396000504</c:v>
                </c:pt>
                <c:pt idx="111">
                  <c:v>0.36072324162000002</c:v>
                </c:pt>
                <c:pt idx="112">
                  <c:v>0.36179074067</c:v>
                </c:pt>
                <c:pt idx="113">
                  <c:v>0.36379649882999998</c:v>
                </c:pt>
                <c:pt idx="114">
                  <c:v>0.36609271048999997</c:v>
                </c:pt>
                <c:pt idx="115">
                  <c:v>0.37071676410000504</c:v>
                </c:pt>
                <c:pt idx="116">
                  <c:v>0.37843883680000318</c:v>
                </c:pt>
                <c:pt idx="117">
                  <c:v>0.38453194636000032</c:v>
                </c:pt>
                <c:pt idx="118">
                  <c:v>0.37784253422000386</c:v>
                </c:pt>
                <c:pt idx="119">
                  <c:v>0.36896819388000646</c:v>
                </c:pt>
                <c:pt idx="120">
                  <c:v>0.35917454500000318</c:v>
                </c:pt>
                <c:pt idx="121">
                  <c:v>0.34942568215000425</c:v>
                </c:pt>
                <c:pt idx="122">
                  <c:v>0.34164797539000374</c:v>
                </c:pt>
                <c:pt idx="123">
                  <c:v>0.33573088792000544</c:v>
                </c:pt>
                <c:pt idx="124">
                  <c:v>0.33222248049000402</c:v>
                </c:pt>
                <c:pt idx="125">
                  <c:v>0.327308176660006</c:v>
                </c:pt>
                <c:pt idx="126">
                  <c:v>0.32419086416000426</c:v>
                </c:pt>
                <c:pt idx="127">
                  <c:v>0.31991737421000516</c:v>
                </c:pt>
                <c:pt idx="128">
                  <c:v>0.31695071117000639</c:v>
                </c:pt>
                <c:pt idx="129">
                  <c:v>0.31596977728000658</c:v>
                </c:pt>
                <c:pt idx="130">
                  <c:v>0.31038276646000629</c:v>
                </c:pt>
                <c:pt idx="131">
                  <c:v>0.30619058162000318</c:v>
                </c:pt>
                <c:pt idx="132">
                  <c:v>0.30006898691000566</c:v>
                </c:pt>
                <c:pt idx="133">
                  <c:v>0.29587674897000515</c:v>
                </c:pt>
                <c:pt idx="134">
                  <c:v>0.28646253935000504</c:v>
                </c:pt>
                <c:pt idx="135">
                  <c:v>0.27681040514000516</c:v>
                </c:pt>
                <c:pt idx="136">
                  <c:v>0.27053797254</c:v>
                </c:pt>
                <c:pt idx="137">
                  <c:v>0.26118454676999997</c:v>
                </c:pt>
                <c:pt idx="138">
                  <c:v>0.25783114655999873</c:v>
                </c:pt>
                <c:pt idx="139">
                  <c:v>0.25942171878999998</c:v>
                </c:pt>
                <c:pt idx="140">
                  <c:v>0.25868203036000031</c:v>
                </c:pt>
                <c:pt idx="141">
                  <c:v>0.25011705826999975</c:v>
                </c:pt>
                <c:pt idx="142">
                  <c:v>0.23663526966999998</c:v>
                </c:pt>
                <c:pt idx="143">
                  <c:v>0.22599789569000173</c:v>
                </c:pt>
                <c:pt idx="144">
                  <c:v>0.21849287851000213</c:v>
                </c:pt>
                <c:pt idx="145">
                  <c:v>0.21091761247000204</c:v>
                </c:pt>
                <c:pt idx="146">
                  <c:v>0.20386169351000041</c:v>
                </c:pt>
                <c:pt idx="147">
                  <c:v>0.19514235485000164</c:v>
                </c:pt>
                <c:pt idx="148">
                  <c:v>0.18866938456000334</c:v>
                </c:pt>
                <c:pt idx="149">
                  <c:v>0.18076823428000258</c:v>
                </c:pt>
                <c:pt idx="150">
                  <c:v>0.17194745600000258</c:v>
                </c:pt>
                <c:pt idx="151">
                  <c:v>0.16314756289999999</c:v>
                </c:pt>
                <c:pt idx="152">
                  <c:v>0.15460247745000041</c:v>
                </c:pt>
                <c:pt idx="153">
                  <c:v>0.1457964435300034</c:v>
                </c:pt>
                <c:pt idx="154">
                  <c:v>0.13580826407999999</c:v>
                </c:pt>
                <c:pt idx="155">
                  <c:v>0.12444341753999999</c:v>
                </c:pt>
                <c:pt idx="156">
                  <c:v>0.11377652586000089</c:v>
                </c:pt>
                <c:pt idx="157">
                  <c:v>0.10224285237000012</c:v>
                </c:pt>
                <c:pt idx="158">
                  <c:v>9.2087898503000226E-2</c:v>
                </c:pt>
                <c:pt idx="159">
                  <c:v>8.1921910299000048E-2</c:v>
                </c:pt>
                <c:pt idx="160">
                  <c:v>7.0860219963000112E-2</c:v>
                </c:pt>
                <c:pt idx="161">
                  <c:v>5.9334707766000104E-2</c:v>
                </c:pt>
                <c:pt idx="162">
                  <c:v>4.9429417683000014E-2</c:v>
                </c:pt>
                <c:pt idx="163">
                  <c:v>4.2968784957001016E-2</c:v>
                </c:pt>
                <c:pt idx="164">
                  <c:v>3.6032975089000677E-2</c:v>
                </c:pt>
                <c:pt idx="165">
                  <c:v>3.0290050198000001E-2</c:v>
                </c:pt>
                <c:pt idx="166">
                  <c:v>2.6196566293999978E-2</c:v>
                </c:pt>
                <c:pt idx="167">
                  <c:v>2.307935857000034E-2</c:v>
                </c:pt>
                <c:pt idx="168">
                  <c:v>2.0933410184000311E-2</c:v>
                </c:pt>
                <c:pt idx="169">
                  <c:v>2.0534633749000001E-2</c:v>
                </c:pt>
                <c:pt idx="170">
                  <c:v>2.1526055850999998E-2</c:v>
                </c:pt>
                <c:pt idx="171">
                  <c:v>2.1017980319000006E-2</c:v>
                </c:pt>
                <c:pt idx="172">
                  <c:v>1.9111872389000223E-2</c:v>
                </c:pt>
                <c:pt idx="173">
                  <c:v>1.7970707770000004E-2</c:v>
                </c:pt>
                <c:pt idx="174">
                  <c:v>1.6532512198000011E-2</c:v>
                </c:pt>
                <c:pt idx="175">
                  <c:v>1.5603039610000228E-2</c:v>
                </c:pt>
                <c:pt idx="176">
                  <c:v>1.5526790825000001E-2</c:v>
                </c:pt>
                <c:pt idx="177">
                  <c:v>1.5886478766000259E-2</c:v>
                </c:pt>
                <c:pt idx="178">
                  <c:v>1.6322715401000061E-2</c:v>
                </c:pt>
                <c:pt idx="179">
                  <c:v>1.6150532040000061E-2</c:v>
                </c:pt>
                <c:pt idx="180">
                  <c:v>1.604896999700002E-2</c:v>
                </c:pt>
                <c:pt idx="181">
                  <c:v>1.6870887073000003E-2</c:v>
                </c:pt>
                <c:pt idx="182">
                  <c:v>1.8950995037000023E-2</c:v>
                </c:pt>
                <c:pt idx="183">
                  <c:v>2.0784634444999998E-2</c:v>
                </c:pt>
                <c:pt idx="184">
                  <c:v>2.0759182815000006E-2</c:v>
                </c:pt>
                <c:pt idx="185">
                  <c:v>2.0321229096000003E-2</c:v>
                </c:pt>
                <c:pt idx="186">
                  <c:v>2.2340960226000052E-2</c:v>
                </c:pt>
                <c:pt idx="187">
                  <c:v>2.8413469605000002E-2</c:v>
                </c:pt>
                <c:pt idx="188">
                  <c:v>3.3630889219000003E-2</c:v>
                </c:pt>
                <c:pt idx="189">
                  <c:v>3.3638648320000041E-2</c:v>
                </c:pt>
                <c:pt idx="190">
                  <c:v>3.1182457281000005E-2</c:v>
                </c:pt>
                <c:pt idx="191">
                  <c:v>2.9822332718000302E-2</c:v>
                </c:pt>
                <c:pt idx="192">
                  <c:v>2.9002240004000052E-2</c:v>
                </c:pt>
                <c:pt idx="193">
                  <c:v>3.1216262923000313E-2</c:v>
                </c:pt>
                <c:pt idx="194">
                  <c:v>3.5442218959000092E-2</c:v>
                </c:pt>
                <c:pt idx="195">
                  <c:v>3.5271957489000749E-2</c:v>
                </c:pt>
                <c:pt idx="196">
                  <c:v>3.1719728513000041E-2</c:v>
                </c:pt>
                <c:pt idx="197">
                  <c:v>3.0131306450000415E-2</c:v>
                </c:pt>
                <c:pt idx="198">
                  <c:v>3.0044813190000005E-2</c:v>
                </c:pt>
                <c:pt idx="199">
                  <c:v>3.0248531665000005E-2</c:v>
                </c:pt>
                <c:pt idx="200">
                  <c:v>3.0953103747000051E-2</c:v>
                </c:pt>
                <c:pt idx="201">
                  <c:v>3.3296641711000011E-2</c:v>
                </c:pt>
                <c:pt idx="202">
                  <c:v>3.5931700846000052E-2</c:v>
                </c:pt>
                <c:pt idx="203">
                  <c:v>3.5803160350000016E-2</c:v>
                </c:pt>
                <c:pt idx="204">
                  <c:v>3.4441881818000016E-2</c:v>
                </c:pt>
                <c:pt idx="205">
                  <c:v>3.2585522647000015E-2</c:v>
                </c:pt>
                <c:pt idx="206">
                  <c:v>3.0101551881000006E-2</c:v>
                </c:pt>
                <c:pt idx="207">
                  <c:v>2.7359485468000051E-2</c:v>
                </c:pt>
                <c:pt idx="208">
                  <c:v>2.4944836041E-2</c:v>
                </c:pt>
                <c:pt idx="209">
                  <c:v>2.3403937183000448E-2</c:v>
                </c:pt>
                <c:pt idx="210">
                  <c:v>2.2120425588000002E-2</c:v>
                </c:pt>
                <c:pt idx="211">
                  <c:v>2.0880865897000042E-2</c:v>
                </c:pt>
                <c:pt idx="212">
                  <c:v>2.0544061568000004E-2</c:v>
                </c:pt>
                <c:pt idx="213">
                  <c:v>2.1078093938000003E-2</c:v>
                </c:pt>
                <c:pt idx="214">
                  <c:v>1.9889298911000001E-2</c:v>
                </c:pt>
                <c:pt idx="215">
                  <c:v>1.6445039230000239E-2</c:v>
                </c:pt>
                <c:pt idx="216">
                  <c:v>1.3735112281000003E-2</c:v>
                </c:pt>
                <c:pt idx="217">
                  <c:v>1.1863285613000247E-2</c:v>
                </c:pt>
                <c:pt idx="218">
                  <c:v>1.0439025055999999E-2</c:v>
                </c:pt>
                <c:pt idx="219">
                  <c:v>9.2872448251000248E-3</c:v>
                </c:pt>
                <c:pt idx="220">
                  <c:v>8.3516380360001731E-3</c:v>
                </c:pt>
                <c:pt idx="221">
                  <c:v>7.6413876360000013E-3</c:v>
                </c:pt>
                <c:pt idx="222">
                  <c:v>6.9440351585000034E-3</c:v>
                </c:pt>
                <c:pt idx="223">
                  <c:v>6.4435174183000024E-3</c:v>
                </c:pt>
                <c:pt idx="224">
                  <c:v>5.9669507204000013E-3</c:v>
                </c:pt>
                <c:pt idx="225">
                  <c:v>5.4559174875000024E-3</c:v>
                </c:pt>
                <c:pt idx="226">
                  <c:v>5.0825423548000034E-3</c:v>
                </c:pt>
                <c:pt idx="227">
                  <c:v>4.8173960555000011E-3</c:v>
                </c:pt>
                <c:pt idx="228">
                  <c:v>4.5555257692000001E-3</c:v>
                </c:pt>
                <c:pt idx="229">
                  <c:v>4.4333722372000587E-3</c:v>
                </c:pt>
                <c:pt idx="230">
                  <c:v>4.3448132292999856E-3</c:v>
                </c:pt>
                <c:pt idx="231">
                  <c:v>4.2409470071000013E-3</c:v>
                </c:pt>
                <c:pt idx="232">
                  <c:v>4.1774041981000008E-3</c:v>
                </c:pt>
                <c:pt idx="233">
                  <c:v>4.1694291008000433E-3</c:v>
                </c:pt>
                <c:pt idx="234">
                  <c:v>4.1361152243999865E-3</c:v>
                </c:pt>
                <c:pt idx="235">
                  <c:v>4.1074043106E-3</c:v>
                </c:pt>
                <c:pt idx="236">
                  <c:v>4.1398538131000124E-3</c:v>
                </c:pt>
                <c:pt idx="237">
                  <c:v>4.1664695826000124E-3</c:v>
                </c:pt>
                <c:pt idx="238">
                  <c:v>4.193242699500074E-3</c:v>
                </c:pt>
                <c:pt idx="239">
                  <c:v>4.2381735068999999E-3</c:v>
                </c:pt>
                <c:pt idx="240">
                  <c:v>4.2792646158001189E-3</c:v>
                </c:pt>
                <c:pt idx="241">
                  <c:v>4.3072156620000005E-3</c:v>
                </c:pt>
                <c:pt idx="242">
                  <c:v>4.2697514082000124E-3</c:v>
                </c:pt>
                <c:pt idx="243">
                  <c:v>4.3319262490000001E-3</c:v>
                </c:pt>
                <c:pt idx="244">
                  <c:v>4.3332975457000674E-3</c:v>
                </c:pt>
                <c:pt idx="245">
                  <c:v>4.3804797156000736E-3</c:v>
                </c:pt>
                <c:pt idx="246">
                  <c:v>4.3614136923000113E-3</c:v>
                </c:pt>
                <c:pt idx="247">
                  <c:v>4.3709588873000003E-3</c:v>
                </c:pt>
                <c:pt idx="248">
                  <c:v>4.3861598712999945E-3</c:v>
                </c:pt>
                <c:pt idx="249">
                  <c:v>4.3651853801999945E-3</c:v>
                </c:pt>
                <c:pt idx="250">
                  <c:v>4.3691110531000003E-3</c:v>
                </c:pt>
                <c:pt idx="251">
                  <c:v>4.2814030304000718E-3</c:v>
                </c:pt>
                <c:pt idx="252">
                  <c:v>4.2449500984999946E-3</c:v>
                </c:pt>
                <c:pt idx="253">
                  <c:v>4.1865151226999995E-3</c:v>
                </c:pt>
                <c:pt idx="254">
                  <c:v>4.1903828184E-3</c:v>
                </c:pt>
                <c:pt idx="255">
                  <c:v>4.1565565459000002E-3</c:v>
                </c:pt>
                <c:pt idx="256">
                  <c:v>4.0734854793999997E-3</c:v>
                </c:pt>
                <c:pt idx="257">
                  <c:v>4.0488600069000114E-3</c:v>
                </c:pt>
                <c:pt idx="258">
                  <c:v>4.0417861701000013E-3</c:v>
                </c:pt>
                <c:pt idx="259">
                  <c:v>4.0104802037999945E-3</c:v>
                </c:pt>
                <c:pt idx="260">
                  <c:v>3.985928784200044E-3</c:v>
                </c:pt>
                <c:pt idx="261">
                  <c:v>4.0047188473999766E-3</c:v>
                </c:pt>
                <c:pt idx="262">
                  <c:v>3.9790588374000006E-3</c:v>
                </c:pt>
                <c:pt idx="263">
                  <c:v>4.0078855433999675E-3</c:v>
                </c:pt>
                <c:pt idx="264">
                  <c:v>4.0043593122000114E-3</c:v>
                </c:pt>
                <c:pt idx="265">
                  <c:v>4.0059417502000113E-3</c:v>
                </c:pt>
                <c:pt idx="266">
                  <c:v>4.0298099697000014E-3</c:v>
                </c:pt>
                <c:pt idx="267">
                  <c:v>4.0249671430999997E-3</c:v>
                </c:pt>
                <c:pt idx="268">
                  <c:v>4.1243490479000002E-3</c:v>
                </c:pt>
                <c:pt idx="269">
                  <c:v>4.1978313503999755E-3</c:v>
                </c:pt>
                <c:pt idx="270">
                  <c:v>4.3185427251000033E-3</c:v>
                </c:pt>
                <c:pt idx="271">
                  <c:v>4.4224154392E-3</c:v>
                </c:pt>
                <c:pt idx="272">
                  <c:v>4.5965488632000034E-3</c:v>
                </c:pt>
                <c:pt idx="273">
                  <c:v>4.7236700081000034E-3</c:v>
                </c:pt>
                <c:pt idx="274">
                  <c:v>4.8581893879000009E-3</c:v>
                </c:pt>
                <c:pt idx="275">
                  <c:v>5.0669546143000009E-3</c:v>
                </c:pt>
                <c:pt idx="276">
                  <c:v>5.2597820285000124E-3</c:v>
                </c:pt>
                <c:pt idx="277">
                  <c:v>5.4615103029000012E-3</c:v>
                </c:pt>
                <c:pt idx="278">
                  <c:v>5.6229407932000012E-3</c:v>
                </c:pt>
                <c:pt idx="279">
                  <c:v>5.8400754222000034E-3</c:v>
                </c:pt>
                <c:pt idx="280">
                  <c:v>6.0789425686999998E-3</c:v>
                </c:pt>
                <c:pt idx="281">
                  <c:v>6.3171363955000113E-3</c:v>
                </c:pt>
                <c:pt idx="282">
                  <c:v>6.5551112946000004E-3</c:v>
                </c:pt>
                <c:pt idx="283">
                  <c:v>6.8401657227000652E-3</c:v>
                </c:pt>
                <c:pt idx="284">
                  <c:v>6.9997686566000859E-3</c:v>
                </c:pt>
                <c:pt idx="285">
                  <c:v>7.2487658866000719E-3</c:v>
                </c:pt>
                <c:pt idx="286">
                  <c:v>7.5246416745000134E-3</c:v>
                </c:pt>
                <c:pt idx="287">
                  <c:v>7.7195232264000114E-3</c:v>
                </c:pt>
                <c:pt idx="288">
                  <c:v>7.9636750875000904E-3</c:v>
                </c:pt>
                <c:pt idx="289">
                  <c:v>8.2094688886000227E-3</c:v>
                </c:pt>
                <c:pt idx="290">
                  <c:v>8.3869847096001565E-3</c:v>
                </c:pt>
                <c:pt idx="291">
                  <c:v>8.5698348225001775E-3</c:v>
                </c:pt>
                <c:pt idx="292">
                  <c:v>8.7366810334000063E-3</c:v>
                </c:pt>
                <c:pt idx="293">
                  <c:v>8.9109938176001324E-3</c:v>
                </c:pt>
                <c:pt idx="294">
                  <c:v>9.1034555979001546E-3</c:v>
                </c:pt>
                <c:pt idx="295">
                  <c:v>9.3141472361001655E-3</c:v>
                </c:pt>
                <c:pt idx="296">
                  <c:v>9.4466934758000044E-3</c:v>
                </c:pt>
                <c:pt idx="297">
                  <c:v>9.5620766703001462E-3</c:v>
                </c:pt>
                <c:pt idx="298">
                  <c:v>9.7110632689000002E-3</c:v>
                </c:pt>
                <c:pt idx="299">
                  <c:v>9.8371959075000247E-3</c:v>
                </c:pt>
                <c:pt idx="300">
                  <c:v>1.0044654394000103E-2</c:v>
                </c:pt>
                <c:pt idx="301">
                  <c:v>1.0157425755000003E-2</c:v>
                </c:pt>
                <c:pt idx="302">
                  <c:v>1.0339855165000005E-2</c:v>
                </c:pt>
                <c:pt idx="303">
                  <c:v>1.0498186417999999E-2</c:v>
                </c:pt>
                <c:pt idx="304">
                  <c:v>1.0585593942000001E-2</c:v>
                </c:pt>
                <c:pt idx="305">
                  <c:v>1.0635079947000147E-2</c:v>
                </c:pt>
                <c:pt idx="306">
                  <c:v>1.0819403819000003E-2</c:v>
                </c:pt>
                <c:pt idx="307">
                  <c:v>1.0862682328000002E-2</c:v>
                </c:pt>
                <c:pt idx="308">
                  <c:v>1.094614574400019E-2</c:v>
                </c:pt>
                <c:pt idx="309">
                  <c:v>1.1066354038000145E-2</c:v>
                </c:pt>
                <c:pt idx="310">
                  <c:v>1.1221297272999999E-2</c:v>
                </c:pt>
                <c:pt idx="311">
                  <c:v>1.1206861944000166E-2</c:v>
                </c:pt>
                <c:pt idx="312">
                  <c:v>1.1202329280000228E-2</c:v>
                </c:pt>
                <c:pt idx="313">
                  <c:v>1.1250551488000199E-2</c:v>
                </c:pt>
                <c:pt idx="314">
                  <c:v>1.1227668739000041E-2</c:v>
                </c:pt>
                <c:pt idx="315">
                  <c:v>1.1228428367000229E-2</c:v>
                </c:pt>
                <c:pt idx="316">
                  <c:v>1.1198850811000041E-2</c:v>
                </c:pt>
                <c:pt idx="317">
                  <c:v>1.1182558621000219E-2</c:v>
                </c:pt>
                <c:pt idx="318">
                  <c:v>1.1193236927999809E-2</c:v>
                </c:pt>
                <c:pt idx="319">
                  <c:v>1.1205767376000007E-2</c:v>
                </c:pt>
                <c:pt idx="320">
                  <c:v>1.1222733581999999E-2</c:v>
                </c:pt>
                <c:pt idx="321">
                  <c:v>1.1236317542E-2</c:v>
                </c:pt>
                <c:pt idx="322">
                  <c:v>1.1262868255000207E-2</c:v>
                </c:pt>
                <c:pt idx="323">
                  <c:v>1.1344968283000021E-2</c:v>
                </c:pt>
                <c:pt idx="324">
                  <c:v>1.1373498961000001E-2</c:v>
                </c:pt>
                <c:pt idx="325">
                  <c:v>1.1475047059E-2</c:v>
                </c:pt>
                <c:pt idx="326">
                  <c:v>1.1532167869000041E-2</c:v>
                </c:pt>
                <c:pt idx="327">
                  <c:v>1.1627741516000134E-2</c:v>
                </c:pt>
                <c:pt idx="328">
                  <c:v>1.1827523713000254E-2</c:v>
                </c:pt>
                <c:pt idx="329">
                  <c:v>1.1893926587000002E-2</c:v>
                </c:pt>
                <c:pt idx="330">
                  <c:v>1.2032839693000147E-2</c:v>
                </c:pt>
                <c:pt idx="331">
                  <c:v>1.2183858214000235E-2</c:v>
                </c:pt>
                <c:pt idx="332">
                  <c:v>1.2440391534000002E-2</c:v>
                </c:pt>
                <c:pt idx="333">
                  <c:v>1.2495345281000001E-2</c:v>
                </c:pt>
                <c:pt idx="334">
                  <c:v>1.2743278158E-2</c:v>
                </c:pt>
                <c:pt idx="335">
                  <c:v>1.2855908011000002E-2</c:v>
                </c:pt>
                <c:pt idx="336">
                  <c:v>1.3000372692000189E-2</c:v>
                </c:pt>
                <c:pt idx="337">
                  <c:v>1.3182603562000001E-2</c:v>
                </c:pt>
                <c:pt idx="338">
                  <c:v>1.330745404000019E-2</c:v>
                </c:pt>
                <c:pt idx="339">
                  <c:v>1.3366745741000148E-2</c:v>
                </c:pt>
                <c:pt idx="340">
                  <c:v>1.3433109650000151E-2</c:v>
                </c:pt>
                <c:pt idx="341">
                  <c:v>1.3323750737000187E-2</c:v>
                </c:pt>
                <c:pt idx="342">
                  <c:v>1.3186051709000177E-2</c:v>
                </c:pt>
                <c:pt idx="343">
                  <c:v>1.3063138296000254E-2</c:v>
                </c:pt>
                <c:pt idx="344">
                  <c:v>1.2814501191000041E-2</c:v>
                </c:pt>
                <c:pt idx="345">
                  <c:v>1.2656917300999838E-2</c:v>
                </c:pt>
                <c:pt idx="346">
                  <c:v>1.2537880057000001E-2</c:v>
                </c:pt>
                <c:pt idx="347">
                  <c:v>1.2360825331000228E-2</c:v>
                </c:pt>
                <c:pt idx="348">
                  <c:v>1.2255269977999802E-2</c:v>
                </c:pt>
                <c:pt idx="349">
                  <c:v>1.2141172345000185E-2</c:v>
                </c:pt>
                <c:pt idx="350">
                  <c:v>1.2176996845999826E-2</c:v>
                </c:pt>
                <c:pt idx="351">
                  <c:v>1.2085019967000003E-2</c:v>
                </c:pt>
                <c:pt idx="352">
                  <c:v>1.2027806833000001E-2</c:v>
                </c:pt>
                <c:pt idx="353">
                  <c:v>1.1823894153000119E-2</c:v>
                </c:pt>
                <c:pt idx="354">
                  <c:v>1.1544978941000147E-2</c:v>
                </c:pt>
                <c:pt idx="355">
                  <c:v>1.1164251814000145E-2</c:v>
                </c:pt>
                <c:pt idx="356">
                  <c:v>1.0843285493000142E-2</c:v>
                </c:pt>
                <c:pt idx="357">
                  <c:v>1.0543061638000175E-2</c:v>
                </c:pt>
                <c:pt idx="358">
                  <c:v>1.0333099669000123E-2</c:v>
                </c:pt>
                <c:pt idx="359">
                  <c:v>1.0083340049999999E-2</c:v>
                </c:pt>
                <c:pt idx="360">
                  <c:v>9.7700551077000066E-3</c:v>
                </c:pt>
                <c:pt idx="361">
                  <c:v>9.5226292629000727E-3</c:v>
                </c:pt>
                <c:pt idx="362">
                  <c:v>9.1899405424000248E-3</c:v>
                </c:pt>
                <c:pt idx="363">
                  <c:v>9.0489856980000005E-3</c:v>
                </c:pt>
                <c:pt idx="364">
                  <c:v>8.7403134667999819E-3</c:v>
                </c:pt>
                <c:pt idx="365">
                  <c:v>8.5939282997000068E-3</c:v>
                </c:pt>
                <c:pt idx="366">
                  <c:v>8.5240944486000021E-3</c:v>
                </c:pt>
                <c:pt idx="367">
                  <c:v>8.433936557400188E-3</c:v>
                </c:pt>
                <c:pt idx="368">
                  <c:v>8.273698426100002E-3</c:v>
                </c:pt>
                <c:pt idx="369">
                  <c:v>7.7842040185000334E-3</c:v>
                </c:pt>
                <c:pt idx="370">
                  <c:v>7.1741841402999966E-3</c:v>
                </c:pt>
                <c:pt idx="371">
                  <c:v>6.6988622801000134E-3</c:v>
                </c:pt>
                <c:pt idx="372">
                  <c:v>6.3493005561999997E-3</c:v>
                </c:pt>
                <c:pt idx="373">
                  <c:v>6.0176034687000534E-3</c:v>
                </c:pt>
                <c:pt idx="374">
                  <c:v>5.969095422300074E-3</c:v>
                </c:pt>
                <c:pt idx="375">
                  <c:v>5.6963177162999996E-3</c:v>
                </c:pt>
                <c:pt idx="376">
                  <c:v>5.413720797900084E-3</c:v>
                </c:pt>
                <c:pt idx="377">
                  <c:v>5.2062217529001082E-3</c:v>
                </c:pt>
                <c:pt idx="378">
                  <c:v>5.0235550868000002E-3</c:v>
                </c:pt>
                <c:pt idx="379">
                  <c:v>4.7953457669999986E-3</c:v>
                </c:pt>
                <c:pt idx="380">
                  <c:v>4.6956930692999997E-3</c:v>
                </c:pt>
                <c:pt idx="381">
                  <c:v>4.5249017533000001E-3</c:v>
                </c:pt>
                <c:pt idx="382">
                  <c:v>4.3720407749000033E-3</c:v>
                </c:pt>
                <c:pt idx="383">
                  <c:v>4.2247780675999875E-3</c:v>
                </c:pt>
                <c:pt idx="384">
                  <c:v>4.1321576494999955E-3</c:v>
                </c:pt>
                <c:pt idx="385">
                  <c:v>4.0315426991000816E-3</c:v>
                </c:pt>
                <c:pt idx="386">
                  <c:v>3.9365497343000011E-3</c:v>
                </c:pt>
                <c:pt idx="387">
                  <c:v>3.8353631003000006E-3</c:v>
                </c:pt>
                <c:pt idx="388">
                  <c:v>3.7048671089000497E-3</c:v>
                </c:pt>
                <c:pt idx="389">
                  <c:v>3.6038962971000552E-3</c:v>
                </c:pt>
                <c:pt idx="390">
                  <c:v>3.4678720972000092E-3</c:v>
                </c:pt>
                <c:pt idx="391">
                  <c:v>3.4543266550000314E-3</c:v>
                </c:pt>
                <c:pt idx="392">
                  <c:v>3.4258732456000315E-3</c:v>
                </c:pt>
                <c:pt idx="393">
                  <c:v>3.3860295287000252E-3</c:v>
                </c:pt>
                <c:pt idx="394">
                  <c:v>3.3565561803999997E-3</c:v>
                </c:pt>
                <c:pt idx="395">
                  <c:v>3.3636510548000326E-3</c:v>
                </c:pt>
                <c:pt idx="396">
                  <c:v>3.2590191631000002E-3</c:v>
                </c:pt>
                <c:pt idx="397">
                  <c:v>3.2116805829000383E-3</c:v>
                </c:pt>
                <c:pt idx="398">
                  <c:v>3.1732894457000317E-3</c:v>
                </c:pt>
                <c:pt idx="399">
                  <c:v>3.170539187900041E-3</c:v>
                </c:pt>
                <c:pt idx="400">
                  <c:v>3.2126785153000002E-3</c:v>
                </c:pt>
                <c:pt idx="401">
                  <c:v>3.3615102967000376E-3</c:v>
                </c:pt>
                <c:pt idx="402">
                  <c:v>3.8315335209000052E-3</c:v>
                </c:pt>
                <c:pt idx="403">
                  <c:v>4.1842094745000134E-3</c:v>
                </c:pt>
                <c:pt idx="404">
                  <c:v>4.1860738552000022E-3</c:v>
                </c:pt>
                <c:pt idx="405">
                  <c:v>4.1002049582999946E-3</c:v>
                </c:pt>
                <c:pt idx="406">
                  <c:v>4.2491364736000114E-3</c:v>
                </c:pt>
                <c:pt idx="407">
                  <c:v>4.5620202565999765E-3</c:v>
                </c:pt>
                <c:pt idx="408">
                  <c:v>4.8833370485999996E-3</c:v>
                </c:pt>
                <c:pt idx="409">
                  <c:v>5.0910759670999995E-3</c:v>
                </c:pt>
                <c:pt idx="410">
                  <c:v>5.0283042531000001E-3</c:v>
                </c:pt>
                <c:pt idx="411">
                  <c:v>4.8163594877000688E-3</c:v>
                </c:pt>
                <c:pt idx="412">
                  <c:v>4.6371201926000433E-3</c:v>
                </c:pt>
                <c:pt idx="413">
                  <c:v>4.5041835245999955E-3</c:v>
                </c:pt>
                <c:pt idx="414">
                  <c:v>4.5029604644000014E-3</c:v>
                </c:pt>
                <c:pt idx="415">
                  <c:v>4.5629480574999855E-3</c:v>
                </c:pt>
                <c:pt idx="416">
                  <c:v>4.6972009506000001E-3</c:v>
                </c:pt>
                <c:pt idx="417">
                  <c:v>4.9820556987000024E-3</c:v>
                </c:pt>
                <c:pt idx="418">
                  <c:v>5.1439727717000104E-3</c:v>
                </c:pt>
                <c:pt idx="419">
                  <c:v>5.2536261222000877E-3</c:v>
                </c:pt>
                <c:pt idx="420">
                  <c:v>5.3293529260000014E-3</c:v>
                </c:pt>
                <c:pt idx="421">
                  <c:v>5.4440707410000014E-3</c:v>
                </c:pt>
                <c:pt idx="422">
                  <c:v>5.5737406569000133E-3</c:v>
                </c:pt>
                <c:pt idx="423">
                  <c:v>5.7809105094999945E-3</c:v>
                </c:pt>
                <c:pt idx="424">
                  <c:v>6.0355342473999846E-3</c:v>
                </c:pt>
                <c:pt idx="425">
                  <c:v>6.4673721561000104E-3</c:v>
                </c:pt>
                <c:pt idx="426">
                  <c:v>7.0160833085000113E-3</c:v>
                </c:pt>
                <c:pt idx="427">
                  <c:v>7.6837094436000971E-3</c:v>
                </c:pt>
                <c:pt idx="428">
                  <c:v>8.5426871374001349E-3</c:v>
                </c:pt>
                <c:pt idx="429">
                  <c:v>9.6749500417000027E-3</c:v>
                </c:pt>
                <c:pt idx="430">
                  <c:v>1.0545270179E-2</c:v>
                </c:pt>
                <c:pt idx="431">
                  <c:v>1.0881918757000003E-2</c:v>
                </c:pt>
                <c:pt idx="432">
                  <c:v>1.0561506746000203E-2</c:v>
                </c:pt>
                <c:pt idx="433">
                  <c:v>1.0105287413000003E-2</c:v>
                </c:pt>
                <c:pt idx="434">
                  <c:v>9.7073974369000018E-3</c:v>
                </c:pt>
                <c:pt idx="435">
                  <c:v>9.4362269001000022E-3</c:v>
                </c:pt>
                <c:pt idx="436">
                  <c:v>9.2704231836000014E-3</c:v>
                </c:pt>
                <c:pt idx="437">
                  <c:v>9.1489447574000047E-3</c:v>
                </c:pt>
                <c:pt idx="438">
                  <c:v>9.0712984772000037E-3</c:v>
                </c:pt>
                <c:pt idx="439">
                  <c:v>9.0272568368001248E-3</c:v>
                </c:pt>
                <c:pt idx="440">
                  <c:v>8.9707367286001646E-3</c:v>
                </c:pt>
                <c:pt idx="441">
                  <c:v>9.0938102241000206E-3</c:v>
                </c:pt>
                <c:pt idx="442">
                  <c:v>9.270293347200002E-3</c:v>
                </c:pt>
                <c:pt idx="443">
                  <c:v>9.4650956845001247E-3</c:v>
                </c:pt>
                <c:pt idx="444">
                  <c:v>9.8226795213000768E-3</c:v>
                </c:pt>
                <c:pt idx="445">
                  <c:v>1.0332917446E-2</c:v>
                </c:pt>
                <c:pt idx="446">
                  <c:v>1.1083801124000143E-2</c:v>
                </c:pt>
                <c:pt idx="447">
                  <c:v>1.1874929693000221E-2</c:v>
                </c:pt>
                <c:pt idx="448">
                  <c:v>1.2149265341000005E-2</c:v>
                </c:pt>
                <c:pt idx="449">
                  <c:v>1.2241566998000003E-2</c:v>
                </c:pt>
                <c:pt idx="450">
                  <c:v>1.2980175844000283E-2</c:v>
                </c:pt>
                <c:pt idx="451">
                  <c:v>1.3930158083000169E-2</c:v>
                </c:pt>
                <c:pt idx="452">
                  <c:v>1.4213110773000002E-2</c:v>
                </c:pt>
                <c:pt idx="453">
                  <c:v>1.3437763727999994E-2</c:v>
                </c:pt>
                <c:pt idx="454">
                  <c:v>1.2199761428E-2</c:v>
                </c:pt>
                <c:pt idx="455">
                  <c:v>1.1304100552000021E-2</c:v>
                </c:pt>
                <c:pt idx="456">
                  <c:v>1.1111994236000023E-2</c:v>
                </c:pt>
                <c:pt idx="457">
                  <c:v>1.1578138262000168E-2</c:v>
                </c:pt>
                <c:pt idx="458">
                  <c:v>1.2361502685000136E-2</c:v>
                </c:pt>
                <c:pt idx="459">
                  <c:v>1.3156979128E-2</c:v>
                </c:pt>
                <c:pt idx="460">
                  <c:v>1.3263228020000007E-2</c:v>
                </c:pt>
                <c:pt idx="461">
                  <c:v>1.2683457897000146E-2</c:v>
                </c:pt>
                <c:pt idx="462">
                  <c:v>1.1885041885000001E-2</c:v>
                </c:pt>
                <c:pt idx="463">
                  <c:v>1.1152332349000021E-2</c:v>
                </c:pt>
                <c:pt idx="464">
                  <c:v>1.0567596774000002E-2</c:v>
                </c:pt>
                <c:pt idx="465">
                  <c:v>1.0152500828999999E-2</c:v>
                </c:pt>
                <c:pt idx="466">
                  <c:v>1.0025439703000023E-2</c:v>
                </c:pt>
                <c:pt idx="467">
                  <c:v>1.0452273728E-2</c:v>
                </c:pt>
                <c:pt idx="468">
                  <c:v>1.0738758030000005E-2</c:v>
                </c:pt>
                <c:pt idx="469">
                  <c:v>1.0555694754999958E-2</c:v>
                </c:pt>
                <c:pt idx="470">
                  <c:v>1.0262203383000001E-2</c:v>
                </c:pt>
                <c:pt idx="471">
                  <c:v>1.0208547149999999E-2</c:v>
                </c:pt>
                <c:pt idx="472">
                  <c:v>9.9846811004000047E-3</c:v>
                </c:pt>
                <c:pt idx="473">
                  <c:v>9.7457345617001194E-3</c:v>
                </c:pt>
                <c:pt idx="474">
                  <c:v>9.5667134555000727E-3</c:v>
                </c:pt>
                <c:pt idx="475">
                  <c:v>9.6305254784000028E-3</c:v>
                </c:pt>
                <c:pt idx="476">
                  <c:v>9.9184130883000227E-3</c:v>
                </c:pt>
                <c:pt idx="477">
                  <c:v>1.0353954273E-2</c:v>
                </c:pt>
                <c:pt idx="478">
                  <c:v>1.0687333816999999E-2</c:v>
                </c:pt>
                <c:pt idx="479">
                  <c:v>1.1008791404000007E-2</c:v>
                </c:pt>
                <c:pt idx="480">
                  <c:v>1.3243094726000005E-2</c:v>
                </c:pt>
                <c:pt idx="481">
                  <c:v>1.9589202946000001E-2</c:v>
                </c:pt>
                <c:pt idx="482">
                  <c:v>2.2526302998000011E-2</c:v>
                </c:pt>
                <c:pt idx="483">
                  <c:v>1.690182110600031E-2</c:v>
                </c:pt>
                <c:pt idx="484">
                  <c:v>1.1192155118000192E-2</c:v>
                </c:pt>
                <c:pt idx="485">
                  <c:v>8.9289367887000048E-3</c:v>
                </c:pt>
                <c:pt idx="486">
                  <c:v>7.9200952151000023E-3</c:v>
                </c:pt>
                <c:pt idx="487">
                  <c:v>7.2011487022001193E-3</c:v>
                </c:pt>
                <c:pt idx="488">
                  <c:v>6.7697997173000925E-3</c:v>
                </c:pt>
                <c:pt idx="489">
                  <c:v>6.3927533946000845E-3</c:v>
                </c:pt>
                <c:pt idx="490">
                  <c:v>6.0834008441000113E-3</c:v>
                </c:pt>
                <c:pt idx="491">
                  <c:v>5.7716041194000988E-3</c:v>
                </c:pt>
                <c:pt idx="492">
                  <c:v>5.465842764100063E-3</c:v>
                </c:pt>
                <c:pt idx="493">
                  <c:v>5.2066249825000995E-3</c:v>
                </c:pt>
                <c:pt idx="494">
                  <c:v>5.0306311389000623E-3</c:v>
                </c:pt>
                <c:pt idx="495">
                  <c:v>4.8951004648000009E-3</c:v>
                </c:pt>
                <c:pt idx="496">
                  <c:v>4.7959267519000013E-3</c:v>
                </c:pt>
                <c:pt idx="497">
                  <c:v>4.7648721561999955E-3</c:v>
                </c:pt>
                <c:pt idx="498">
                  <c:v>4.9200964613000013E-3</c:v>
                </c:pt>
                <c:pt idx="499">
                  <c:v>5.1620866048999875E-3</c:v>
                </c:pt>
                <c:pt idx="500">
                  <c:v>5.2954451945000976E-3</c:v>
                </c:pt>
                <c:pt idx="501">
                  <c:v>5.3294118323000015E-3</c:v>
                </c:pt>
                <c:pt idx="502">
                  <c:v>5.3156434969000924E-3</c:v>
                </c:pt>
                <c:pt idx="503">
                  <c:v>5.2929961355000534E-3</c:v>
                </c:pt>
                <c:pt idx="504">
                  <c:v>5.4871445889000114E-3</c:v>
                </c:pt>
                <c:pt idx="505">
                  <c:v>6.031658933100102E-3</c:v>
                </c:pt>
                <c:pt idx="506">
                  <c:v>7.4874864252000711E-3</c:v>
                </c:pt>
                <c:pt idx="507">
                  <c:v>9.4843884788000047E-3</c:v>
                </c:pt>
                <c:pt idx="508">
                  <c:v>1.0524442231000002E-2</c:v>
                </c:pt>
                <c:pt idx="509">
                  <c:v>9.6268996020000205E-3</c:v>
                </c:pt>
                <c:pt idx="510">
                  <c:v>8.8250386536001518E-3</c:v>
                </c:pt>
                <c:pt idx="511">
                  <c:v>8.6343256243999987E-3</c:v>
                </c:pt>
                <c:pt idx="512">
                  <c:v>8.9050155803000568E-3</c:v>
                </c:pt>
                <c:pt idx="513">
                  <c:v>9.6687218303000005E-3</c:v>
                </c:pt>
                <c:pt idx="514">
                  <c:v>1.1253131606000171E-2</c:v>
                </c:pt>
                <c:pt idx="515">
                  <c:v>1.2908601292000166E-2</c:v>
                </c:pt>
                <c:pt idx="516">
                  <c:v>1.3310221813000041E-2</c:v>
                </c:pt>
                <c:pt idx="517">
                  <c:v>1.3003938042000123E-2</c:v>
                </c:pt>
                <c:pt idx="518">
                  <c:v>1.2924892736000001E-2</c:v>
                </c:pt>
                <c:pt idx="519">
                  <c:v>1.3057324037000021E-2</c:v>
                </c:pt>
                <c:pt idx="520">
                  <c:v>1.3202248792000005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671744"/>
        <c:axId val="194673280"/>
      </c:scatterChart>
      <c:valAx>
        <c:axId val="194671744"/>
        <c:scaling>
          <c:orientation val="minMax"/>
          <c:max val="500"/>
          <c:min val="28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222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194673280"/>
        <c:crosses val="autoZero"/>
        <c:crossBetween val="midCat"/>
        <c:majorUnit val="20"/>
      </c:valAx>
      <c:valAx>
        <c:axId val="19467328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194671744"/>
        <c:crosses val="autoZero"/>
        <c:crossBetween val="midCat"/>
        <c:minorUnit val="1.0000000000000005E-2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8.721318143453996E-2"/>
          <c:y val="0.1425460235944993"/>
          <c:w val="0.31239132129577585"/>
          <c:h val="0.16568890750097809"/>
        </c:manualLayout>
      </c:layout>
      <c:overlay val="0"/>
      <c:spPr>
        <a:noFill/>
        <a:ln>
          <a:noFill/>
        </a:ln>
      </c:spPr>
      <c:txPr>
        <a:bodyPr/>
        <a:lstStyle/>
        <a:p>
          <a:pPr>
            <a:defRPr sz="1200" b="1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fr-FR"/>
        </a:p>
      </c:txPr>
    </c:legend>
    <c:plotVisOnly val="0"/>
    <c:dispBlanksAs val="gap"/>
    <c:showDLblsOverMax val="0"/>
  </c:chart>
  <c:spPr>
    <a:noFill/>
    <a:ln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12701-6DE1-4AAA-B011-DD751EE91882}" type="datetimeFigureOut">
              <a:rPr lang="fr-FR" smtClean="0"/>
              <a:pPr/>
              <a:t>0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F8E01-53AC-41EB-8B2A-BAFA40AA7B5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/>
          <p:cNvGraphicFramePr>
            <a:graphicFrameLocks noChangeAspect="1"/>
          </p:cNvGraphicFramePr>
          <p:nvPr/>
        </p:nvGraphicFramePr>
        <p:xfrm>
          <a:off x="0" y="1691680"/>
          <a:ext cx="6475919" cy="43924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08"/>
          <p:cNvSpPr>
            <a:spLocks noChangeArrowheads="1"/>
          </p:cNvSpPr>
          <p:nvPr/>
        </p:nvSpPr>
        <p:spPr bwMode="auto">
          <a:xfrm>
            <a:off x="5481981" y="5804763"/>
            <a:ext cx="137602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fr-FR" sz="12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Wavelength</a:t>
            </a:r>
            <a:r>
              <a:rPr lang="fr-FR" sz="12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(nm)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 Box 411"/>
          <p:cNvSpPr txBox="1">
            <a:spLocks noChangeArrowheads="1"/>
          </p:cNvSpPr>
          <p:nvPr/>
        </p:nvSpPr>
        <p:spPr bwMode="auto">
          <a:xfrm>
            <a:off x="1425409" y="5819887"/>
            <a:ext cx="79496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fr-FR" sz="1200" b="1" dirty="0" smtClean="0">
                <a:solidFill>
                  <a:srgbClr val="1C1C1C"/>
                </a:solidFill>
                <a:latin typeface="Arial" pitchFamily="34" charset="0"/>
                <a:cs typeface="Arial" pitchFamily="34" charset="0"/>
              </a:rPr>
              <a:t>UVA2</a:t>
            </a:r>
            <a:endParaRPr lang="fr-FR" sz="1200" b="1" dirty="0">
              <a:solidFill>
                <a:srgbClr val="1C1C1C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 Box 412"/>
          <p:cNvSpPr txBox="1">
            <a:spLocks noChangeArrowheads="1"/>
          </p:cNvSpPr>
          <p:nvPr/>
        </p:nvSpPr>
        <p:spPr bwMode="auto">
          <a:xfrm>
            <a:off x="2596590" y="5809274"/>
            <a:ext cx="58201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UVA1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 Box 10"/>
          <p:cNvSpPr txBox="1">
            <a:spLocks noChangeArrowheads="1"/>
          </p:cNvSpPr>
          <p:nvPr/>
        </p:nvSpPr>
        <p:spPr bwMode="auto">
          <a:xfrm rot="16200000">
            <a:off x="-1153278" y="3739789"/>
            <a:ext cx="2645021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/>
            <a:r>
              <a:rPr lang="fr-FR" sz="1200" dirty="0" smtClean="0">
                <a:latin typeface="Arial" pitchFamily="34" charset="0"/>
                <a:cs typeface="Arial" pitchFamily="34" charset="0"/>
              </a:rPr>
              <a:t>Spectral </a:t>
            </a:r>
            <a:r>
              <a:rPr lang="fr-FR" sz="1200" dirty="0" err="1" smtClean="0">
                <a:latin typeface="Arial" pitchFamily="34" charset="0"/>
                <a:cs typeface="Arial" pitchFamily="34" charset="0"/>
              </a:rPr>
              <a:t>Irradiance</a:t>
            </a:r>
            <a:r>
              <a:rPr lang="fr-FR" sz="1200" dirty="0" smtClean="0">
                <a:latin typeface="Arial" pitchFamily="34" charset="0"/>
                <a:cs typeface="Arial" pitchFamily="34" charset="0"/>
              </a:rPr>
              <a:t> (mW.cm-2.nm-1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cxnSp>
        <p:nvCxnSpPr>
          <p:cNvPr id="10" name="Connecteur droit avec flèche 9"/>
          <p:cNvCxnSpPr/>
          <p:nvPr/>
        </p:nvCxnSpPr>
        <p:spPr>
          <a:xfrm>
            <a:off x="1562026" y="5778913"/>
            <a:ext cx="505800" cy="0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avec flèche 10"/>
          <p:cNvCxnSpPr/>
          <p:nvPr/>
        </p:nvCxnSpPr>
        <p:spPr>
          <a:xfrm>
            <a:off x="2067828" y="5778914"/>
            <a:ext cx="1495666" cy="1129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avec flèche 11"/>
          <p:cNvCxnSpPr/>
          <p:nvPr/>
        </p:nvCxnSpPr>
        <p:spPr>
          <a:xfrm>
            <a:off x="3564321" y="5778007"/>
            <a:ext cx="2465777" cy="0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headEnd type="arrow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 Box 412"/>
          <p:cNvSpPr txBox="1">
            <a:spLocks noChangeArrowheads="1"/>
          </p:cNvSpPr>
          <p:nvPr/>
        </p:nvSpPr>
        <p:spPr bwMode="auto">
          <a:xfrm>
            <a:off x="3699750" y="5815446"/>
            <a:ext cx="104913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Visible light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217912" y="2358075"/>
            <a:ext cx="1876446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36000" rIns="36000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UVA2+UVA1 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(WG335)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1235580" y="2734575"/>
            <a:ext cx="1445349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36000" rIns="36000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UVA1 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WG360)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1</Words>
  <Application>Microsoft Office PowerPoint</Application>
  <PresentationFormat>Affichage à l'écran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L'Oreal 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RIONNET_C</dc:creator>
  <cp:lastModifiedBy>MARIONNET Claire</cp:lastModifiedBy>
  <cp:revision>4</cp:revision>
  <dcterms:created xsi:type="dcterms:W3CDTF">2014-01-24T11:59:10Z</dcterms:created>
  <dcterms:modified xsi:type="dcterms:W3CDTF">2014-05-06T12:51:50Z</dcterms:modified>
</cp:coreProperties>
</file>